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9FB749E-1FE2-4EB1-985A-4482AF2F111B}" type="slidenum">
              <a:rPr b="0" lang="fr-F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76492EB-841E-43F4-8146-576A459240FA}" type="slidenum">
              <a:rPr b="0" lang="fr-F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41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FR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1B9AD2-2244-4981-A920-F6380B7EF57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636642-4D2D-4EF4-B878-88F4272CF72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2DFC2F-D32B-4457-93A7-0BB95F24610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3953BA-5CA6-4C18-B6B7-F141DC8E422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327F9E-0A08-4F29-8B6B-5B829CF289C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40DC1B-DE8D-4B14-BA86-181E9126C1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66FD76-FA0F-4181-90F3-6D4AF28DF3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567E3E-ADB2-439D-8565-E8440B4D84A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A26C2B-5B57-414C-9AC5-EE813ED8039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3A7803-D9EC-425B-9CE9-24CC4B2103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F0755E-8457-4855-8852-E277126776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FE93C7-1B26-4BDF-81EF-09A64B558C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D3DF1B7-BC87-4018-99E5-E091753737D6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551"/>
          <p:cNvSpPr/>
          <p:nvPr/>
        </p:nvSpPr>
        <p:spPr>
          <a:xfrm>
            <a:off x="3982320" y="2719440"/>
            <a:ext cx="712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Arupestris 105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553"/>
          <p:cNvSpPr/>
          <p:nvPr/>
        </p:nvSpPr>
        <p:spPr>
          <a:xfrm>
            <a:off x="477720" y="9043920"/>
            <a:ext cx="219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554"/>
          <p:cNvSpPr/>
          <p:nvPr/>
        </p:nvSpPr>
        <p:spPr>
          <a:xfrm>
            <a:off x="536760" y="889308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0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555"/>
          <p:cNvSpPr/>
          <p:nvPr/>
        </p:nvSpPr>
        <p:spPr>
          <a:xfrm flipH="1">
            <a:off x="1596600" y="363600"/>
            <a:ext cx="5698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556"/>
          <p:cNvSpPr/>
          <p:nvPr/>
        </p:nvSpPr>
        <p:spPr>
          <a:xfrm>
            <a:off x="2221200" y="293760"/>
            <a:ext cx="683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virginica 387 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557"/>
          <p:cNvSpPr/>
          <p:nvPr/>
        </p:nvSpPr>
        <p:spPr>
          <a:xfrm flipH="1">
            <a:off x="2178000" y="482760"/>
            <a:ext cx="1094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558"/>
          <p:cNvSpPr/>
          <p:nvPr/>
        </p:nvSpPr>
        <p:spPr>
          <a:xfrm>
            <a:off x="2351160" y="403200"/>
            <a:ext cx="777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caroliana TG 11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559"/>
          <p:cNvSpPr/>
          <p:nvPr/>
        </p:nvSpPr>
        <p:spPr>
          <a:xfrm flipH="1">
            <a:off x="2178000" y="633240"/>
            <a:ext cx="1000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560"/>
          <p:cNvSpPr/>
          <p:nvPr/>
        </p:nvSpPr>
        <p:spPr>
          <a:xfrm>
            <a:off x="2341800" y="557280"/>
            <a:ext cx="858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virginica TG 117sv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561"/>
          <p:cNvSpPr/>
          <p:nvPr/>
        </p:nvSpPr>
        <p:spPr>
          <a:xfrm flipH="1">
            <a:off x="2836800" y="712800"/>
            <a:ext cx="2304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562"/>
          <p:cNvSpPr/>
          <p:nvPr/>
        </p:nvSpPr>
        <p:spPr>
          <a:xfrm>
            <a:off x="3131280" y="642960"/>
            <a:ext cx="695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caroliniana Sc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563"/>
          <p:cNvSpPr/>
          <p:nvPr/>
        </p:nvSpPr>
        <p:spPr>
          <a:xfrm flipH="1">
            <a:off x="2836800" y="833400"/>
            <a:ext cx="1303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564"/>
          <p:cNvSpPr/>
          <p:nvPr/>
        </p:nvSpPr>
        <p:spPr>
          <a:xfrm>
            <a:off x="3031200" y="752400"/>
            <a:ext cx="695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caroliniana Sc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565"/>
          <p:cNvSpPr/>
          <p:nvPr/>
        </p:nvSpPr>
        <p:spPr>
          <a:xfrm flipH="1">
            <a:off x="2178000" y="773280"/>
            <a:ext cx="6588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566"/>
          <p:cNvSpPr/>
          <p:nvPr/>
        </p:nvSpPr>
        <p:spPr>
          <a:xfrm>
            <a:off x="2836800" y="712800"/>
            <a:ext cx="1800" cy="120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567"/>
          <p:cNvSpPr/>
          <p:nvPr/>
        </p:nvSpPr>
        <p:spPr>
          <a:xfrm>
            <a:off x="2292480" y="790560"/>
            <a:ext cx="576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99/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568"/>
          <p:cNvSpPr/>
          <p:nvPr/>
        </p:nvSpPr>
        <p:spPr>
          <a:xfrm flipH="1">
            <a:off x="1596960" y="633240"/>
            <a:ext cx="5810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569"/>
          <p:cNvSpPr/>
          <p:nvPr/>
        </p:nvSpPr>
        <p:spPr>
          <a:xfrm>
            <a:off x="2178000" y="482760"/>
            <a:ext cx="1800" cy="2905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570"/>
          <p:cNvSpPr/>
          <p:nvPr/>
        </p:nvSpPr>
        <p:spPr>
          <a:xfrm>
            <a:off x="1675080" y="503280"/>
            <a:ext cx="447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98/9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571"/>
          <p:cNvSpPr/>
          <p:nvPr/>
        </p:nvSpPr>
        <p:spPr>
          <a:xfrm flipH="1">
            <a:off x="477360" y="493560"/>
            <a:ext cx="11192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572"/>
          <p:cNvSpPr/>
          <p:nvPr/>
        </p:nvSpPr>
        <p:spPr>
          <a:xfrm>
            <a:off x="1596960" y="363600"/>
            <a:ext cx="1800" cy="2696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573"/>
          <p:cNvSpPr/>
          <p:nvPr/>
        </p:nvSpPr>
        <p:spPr>
          <a:xfrm>
            <a:off x="954360" y="358920"/>
            <a:ext cx="447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96/9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574"/>
          <p:cNvSpPr/>
          <p:nvPr/>
        </p:nvSpPr>
        <p:spPr>
          <a:xfrm flipH="1">
            <a:off x="477720" y="952560"/>
            <a:ext cx="5796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575"/>
          <p:cNvSpPr/>
          <p:nvPr/>
        </p:nvSpPr>
        <p:spPr>
          <a:xfrm>
            <a:off x="1112760" y="873000"/>
            <a:ext cx="695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sylvestris 673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ine 576"/>
          <p:cNvSpPr/>
          <p:nvPr/>
        </p:nvSpPr>
        <p:spPr>
          <a:xfrm flipH="1">
            <a:off x="887040" y="1116000"/>
            <a:ext cx="7700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577"/>
          <p:cNvSpPr/>
          <p:nvPr/>
        </p:nvSpPr>
        <p:spPr>
          <a:xfrm>
            <a:off x="1744920" y="1042920"/>
            <a:ext cx="829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tellaria sp. TG 32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578"/>
          <p:cNvSpPr/>
          <p:nvPr/>
        </p:nvSpPr>
        <p:spPr>
          <a:xfrm flipH="1">
            <a:off x="1707840" y="3417840"/>
            <a:ext cx="1299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579"/>
          <p:cNvSpPr/>
          <p:nvPr/>
        </p:nvSpPr>
        <p:spPr>
          <a:xfrm>
            <a:off x="1901880" y="3348000"/>
            <a:ext cx="743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caulis bernoull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580"/>
          <p:cNvSpPr/>
          <p:nvPr/>
        </p:nvSpPr>
        <p:spPr>
          <a:xfrm flipH="1">
            <a:off x="1937880" y="3538440"/>
            <a:ext cx="1191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581"/>
          <p:cNvSpPr/>
          <p:nvPr/>
        </p:nvSpPr>
        <p:spPr>
          <a:xfrm>
            <a:off x="2112480" y="3457440"/>
            <a:ext cx="628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caulis 314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582"/>
          <p:cNvSpPr/>
          <p:nvPr/>
        </p:nvSpPr>
        <p:spPr>
          <a:xfrm flipH="1">
            <a:off x="1938240" y="3662280"/>
            <a:ext cx="3492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583"/>
          <p:cNvSpPr/>
          <p:nvPr/>
        </p:nvSpPr>
        <p:spPr>
          <a:xfrm>
            <a:off x="2342520" y="3578400"/>
            <a:ext cx="628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caulis 314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584"/>
          <p:cNvSpPr/>
          <p:nvPr/>
        </p:nvSpPr>
        <p:spPr>
          <a:xfrm>
            <a:off x="2343600" y="3724200"/>
            <a:ext cx="524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caulis 38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585"/>
          <p:cNvSpPr/>
          <p:nvPr/>
        </p:nvSpPr>
        <p:spPr>
          <a:xfrm>
            <a:off x="2334960" y="3833640"/>
            <a:ext cx="523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caulis Sa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586"/>
          <p:cNvSpPr/>
          <p:nvPr/>
        </p:nvSpPr>
        <p:spPr>
          <a:xfrm>
            <a:off x="2334960" y="3954600"/>
            <a:ext cx="523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caulis Sa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587"/>
          <p:cNvSpPr/>
          <p:nvPr/>
        </p:nvSpPr>
        <p:spPr>
          <a:xfrm flipH="1">
            <a:off x="2039400" y="3794040"/>
            <a:ext cx="2286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588"/>
          <p:cNvSpPr/>
          <p:nvPr/>
        </p:nvSpPr>
        <p:spPr>
          <a:xfrm flipH="1">
            <a:off x="1937880" y="3794040"/>
            <a:ext cx="1112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589"/>
          <p:cNvSpPr/>
          <p:nvPr/>
        </p:nvSpPr>
        <p:spPr>
          <a:xfrm flipH="1">
            <a:off x="1937880" y="3916440"/>
            <a:ext cx="1112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Line 590"/>
          <p:cNvSpPr/>
          <p:nvPr/>
        </p:nvSpPr>
        <p:spPr>
          <a:xfrm flipH="1">
            <a:off x="1937880" y="4033800"/>
            <a:ext cx="1112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Line 591"/>
          <p:cNvSpPr/>
          <p:nvPr/>
        </p:nvSpPr>
        <p:spPr>
          <a:xfrm>
            <a:off x="1708200" y="3794040"/>
            <a:ext cx="1440" cy="2397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Line 592"/>
          <p:cNvSpPr/>
          <p:nvPr/>
        </p:nvSpPr>
        <p:spPr>
          <a:xfrm flipH="1">
            <a:off x="1707840" y="4033800"/>
            <a:ext cx="2300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Line 593"/>
          <p:cNvSpPr/>
          <p:nvPr/>
        </p:nvSpPr>
        <p:spPr>
          <a:xfrm>
            <a:off x="1708200" y="1546200"/>
            <a:ext cx="1440" cy="2270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Line 594"/>
          <p:cNvSpPr/>
          <p:nvPr/>
        </p:nvSpPr>
        <p:spPr>
          <a:xfrm flipH="1">
            <a:off x="887400" y="1913040"/>
            <a:ext cx="8208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595"/>
          <p:cNvSpPr/>
          <p:nvPr/>
        </p:nvSpPr>
        <p:spPr>
          <a:xfrm>
            <a:off x="1099080" y="1798560"/>
            <a:ext cx="447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0.96/81/9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Line 596"/>
          <p:cNvSpPr/>
          <p:nvPr/>
        </p:nvSpPr>
        <p:spPr>
          <a:xfrm flipH="1">
            <a:off x="1807920" y="4222800"/>
            <a:ext cx="1299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Rectangle 597"/>
          <p:cNvSpPr/>
          <p:nvPr/>
        </p:nvSpPr>
        <p:spPr>
          <a:xfrm>
            <a:off x="1992240" y="4152960"/>
            <a:ext cx="625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Lflos jovis 4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598"/>
          <p:cNvSpPr/>
          <p:nvPr/>
        </p:nvSpPr>
        <p:spPr>
          <a:xfrm flipH="1">
            <a:off x="1808280" y="4343400"/>
            <a:ext cx="1094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599"/>
          <p:cNvSpPr/>
          <p:nvPr/>
        </p:nvSpPr>
        <p:spPr>
          <a:xfrm>
            <a:off x="1973520" y="4262400"/>
            <a:ext cx="665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Lflos jovis M2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600"/>
          <p:cNvSpPr/>
          <p:nvPr/>
        </p:nvSpPr>
        <p:spPr>
          <a:xfrm flipH="1">
            <a:off x="1447560" y="4282920"/>
            <a:ext cx="3603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601"/>
          <p:cNvSpPr/>
          <p:nvPr/>
        </p:nvSpPr>
        <p:spPr>
          <a:xfrm>
            <a:off x="1808280" y="4222800"/>
            <a:ext cx="1440" cy="120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602"/>
          <p:cNvSpPr/>
          <p:nvPr/>
        </p:nvSpPr>
        <p:spPr>
          <a:xfrm>
            <a:off x="1314720" y="4140360"/>
            <a:ext cx="447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89/9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Line 603"/>
          <p:cNvSpPr/>
          <p:nvPr/>
        </p:nvSpPr>
        <p:spPr>
          <a:xfrm flipH="1">
            <a:off x="1787040" y="4462560"/>
            <a:ext cx="1098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604"/>
          <p:cNvSpPr/>
          <p:nvPr/>
        </p:nvSpPr>
        <p:spPr>
          <a:xfrm>
            <a:off x="1952280" y="4383000"/>
            <a:ext cx="686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Arupestris 383 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Line 605"/>
          <p:cNvSpPr/>
          <p:nvPr/>
        </p:nvSpPr>
        <p:spPr>
          <a:xfrm flipH="1">
            <a:off x="1787040" y="4573440"/>
            <a:ext cx="1098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ectangle 606"/>
          <p:cNvSpPr/>
          <p:nvPr/>
        </p:nvSpPr>
        <p:spPr>
          <a:xfrm>
            <a:off x="1951920" y="4503600"/>
            <a:ext cx="674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vulgaris 3002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Line 607"/>
          <p:cNvSpPr/>
          <p:nvPr/>
        </p:nvSpPr>
        <p:spPr>
          <a:xfrm flipH="1">
            <a:off x="1787040" y="4692600"/>
            <a:ext cx="1098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608"/>
          <p:cNvSpPr/>
          <p:nvPr/>
        </p:nvSpPr>
        <p:spPr>
          <a:xfrm>
            <a:off x="1951920" y="4622760"/>
            <a:ext cx="674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vulgaris 3003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Line 609"/>
          <p:cNvSpPr/>
          <p:nvPr/>
        </p:nvSpPr>
        <p:spPr>
          <a:xfrm flipH="1">
            <a:off x="1787400" y="4813200"/>
            <a:ext cx="1000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ectangle 610"/>
          <p:cNvSpPr/>
          <p:nvPr/>
        </p:nvSpPr>
        <p:spPr>
          <a:xfrm>
            <a:off x="1943280" y="4734000"/>
            <a:ext cx="622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vulgaris 791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Line 611"/>
          <p:cNvSpPr/>
          <p:nvPr/>
        </p:nvSpPr>
        <p:spPr>
          <a:xfrm flipH="1">
            <a:off x="1447560" y="4633920"/>
            <a:ext cx="3394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Line 612"/>
          <p:cNvSpPr/>
          <p:nvPr/>
        </p:nvSpPr>
        <p:spPr>
          <a:xfrm>
            <a:off x="1787400" y="4462560"/>
            <a:ext cx="1800" cy="3506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Rectangle 613"/>
          <p:cNvSpPr/>
          <p:nvPr/>
        </p:nvSpPr>
        <p:spPr>
          <a:xfrm>
            <a:off x="1314720" y="4643280"/>
            <a:ext cx="447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0.97/87/8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ine 614"/>
          <p:cNvSpPr/>
          <p:nvPr/>
        </p:nvSpPr>
        <p:spPr>
          <a:xfrm flipH="1">
            <a:off x="887040" y="4462560"/>
            <a:ext cx="56052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Line 615"/>
          <p:cNvSpPr/>
          <p:nvPr/>
        </p:nvSpPr>
        <p:spPr>
          <a:xfrm>
            <a:off x="1447920" y="4282920"/>
            <a:ext cx="1440" cy="351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616"/>
          <p:cNvSpPr/>
          <p:nvPr/>
        </p:nvSpPr>
        <p:spPr>
          <a:xfrm>
            <a:off x="811800" y="4317840"/>
            <a:ext cx="447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95/9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Line 617"/>
          <p:cNvSpPr/>
          <p:nvPr/>
        </p:nvSpPr>
        <p:spPr>
          <a:xfrm flipH="1">
            <a:off x="1378080" y="4923000"/>
            <a:ext cx="2095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618"/>
          <p:cNvSpPr/>
          <p:nvPr/>
        </p:nvSpPr>
        <p:spPr>
          <a:xfrm>
            <a:off x="1641960" y="4853160"/>
            <a:ext cx="840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ocymoides TG 9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Line 619"/>
          <p:cNvSpPr/>
          <p:nvPr/>
        </p:nvSpPr>
        <p:spPr>
          <a:xfrm flipH="1">
            <a:off x="1377720" y="5043600"/>
            <a:ext cx="6793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Rectangle 620"/>
          <p:cNvSpPr/>
          <p:nvPr/>
        </p:nvSpPr>
        <p:spPr>
          <a:xfrm>
            <a:off x="2113200" y="4973760"/>
            <a:ext cx="666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officinalis R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Line 621"/>
          <p:cNvSpPr/>
          <p:nvPr/>
        </p:nvSpPr>
        <p:spPr>
          <a:xfrm flipH="1">
            <a:off x="1377720" y="5162400"/>
            <a:ext cx="997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622"/>
          <p:cNvSpPr/>
          <p:nvPr/>
        </p:nvSpPr>
        <p:spPr>
          <a:xfrm>
            <a:off x="1532160" y="5083200"/>
            <a:ext cx="863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officinalis TG 11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Line 623"/>
          <p:cNvSpPr/>
          <p:nvPr/>
        </p:nvSpPr>
        <p:spPr>
          <a:xfrm flipH="1">
            <a:off x="1378080" y="5283360"/>
            <a:ext cx="2095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624"/>
          <p:cNvSpPr/>
          <p:nvPr/>
        </p:nvSpPr>
        <p:spPr>
          <a:xfrm>
            <a:off x="1651320" y="5203800"/>
            <a:ext cx="863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officinalis TG 34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Line 625"/>
          <p:cNvSpPr/>
          <p:nvPr/>
        </p:nvSpPr>
        <p:spPr>
          <a:xfrm flipH="1">
            <a:off x="1377720" y="5392800"/>
            <a:ext cx="997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tangle 626"/>
          <p:cNvSpPr/>
          <p:nvPr/>
        </p:nvSpPr>
        <p:spPr>
          <a:xfrm>
            <a:off x="1541520" y="5322960"/>
            <a:ext cx="863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officinalis TG 34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Line 627"/>
          <p:cNvSpPr/>
          <p:nvPr/>
        </p:nvSpPr>
        <p:spPr>
          <a:xfrm flipH="1">
            <a:off x="1378080" y="5513400"/>
            <a:ext cx="1094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Rectangle 628"/>
          <p:cNvSpPr/>
          <p:nvPr/>
        </p:nvSpPr>
        <p:spPr>
          <a:xfrm>
            <a:off x="1542240" y="5432400"/>
            <a:ext cx="817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officinalis TG 13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Line 629"/>
          <p:cNvSpPr/>
          <p:nvPr/>
        </p:nvSpPr>
        <p:spPr>
          <a:xfrm flipH="1">
            <a:off x="1377720" y="5632560"/>
            <a:ext cx="997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Rectangle 630"/>
          <p:cNvSpPr/>
          <p:nvPr/>
        </p:nvSpPr>
        <p:spPr>
          <a:xfrm>
            <a:off x="1542240" y="5553000"/>
            <a:ext cx="817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officinalis TG 13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Line 631"/>
          <p:cNvSpPr/>
          <p:nvPr/>
        </p:nvSpPr>
        <p:spPr>
          <a:xfrm flipH="1">
            <a:off x="887040" y="5283360"/>
            <a:ext cx="4906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Line 632"/>
          <p:cNvSpPr/>
          <p:nvPr/>
        </p:nvSpPr>
        <p:spPr>
          <a:xfrm>
            <a:off x="1378080" y="4923000"/>
            <a:ext cx="1440" cy="709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Rectangle 633"/>
          <p:cNvSpPr/>
          <p:nvPr/>
        </p:nvSpPr>
        <p:spPr>
          <a:xfrm>
            <a:off x="738720" y="5148360"/>
            <a:ext cx="447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93/9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634"/>
          <p:cNvSpPr/>
          <p:nvPr/>
        </p:nvSpPr>
        <p:spPr>
          <a:xfrm flipH="1">
            <a:off x="2147760" y="5743440"/>
            <a:ext cx="2793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Rectangle 635"/>
          <p:cNvSpPr/>
          <p:nvPr/>
        </p:nvSpPr>
        <p:spPr>
          <a:xfrm>
            <a:off x="2483640" y="5673600"/>
            <a:ext cx="744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sylvestris Dsus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Line 636"/>
          <p:cNvSpPr/>
          <p:nvPr/>
        </p:nvSpPr>
        <p:spPr>
          <a:xfrm flipH="1">
            <a:off x="2426760" y="5862600"/>
            <a:ext cx="1098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Rectangle 637"/>
          <p:cNvSpPr/>
          <p:nvPr/>
        </p:nvSpPr>
        <p:spPr>
          <a:xfrm>
            <a:off x="2589480" y="5783400"/>
            <a:ext cx="947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carthusianorum 702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Line 638"/>
          <p:cNvSpPr/>
          <p:nvPr/>
        </p:nvSpPr>
        <p:spPr>
          <a:xfrm flipH="1">
            <a:off x="2426760" y="5983200"/>
            <a:ext cx="1098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Rectangle 639"/>
          <p:cNvSpPr/>
          <p:nvPr/>
        </p:nvSpPr>
        <p:spPr>
          <a:xfrm>
            <a:off x="2589480" y="5904000"/>
            <a:ext cx="947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carthusianorum 751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Line 640"/>
          <p:cNvSpPr/>
          <p:nvPr/>
        </p:nvSpPr>
        <p:spPr>
          <a:xfrm flipH="1">
            <a:off x="2426760" y="6103800"/>
            <a:ext cx="1098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Rectangle 641"/>
          <p:cNvSpPr/>
          <p:nvPr/>
        </p:nvSpPr>
        <p:spPr>
          <a:xfrm>
            <a:off x="2589480" y="6022800"/>
            <a:ext cx="1056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carthusianorum TG 32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Line 642"/>
          <p:cNvSpPr/>
          <p:nvPr/>
        </p:nvSpPr>
        <p:spPr>
          <a:xfrm flipH="1">
            <a:off x="2427120" y="6213600"/>
            <a:ext cx="1000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ctangle 643"/>
          <p:cNvSpPr/>
          <p:nvPr/>
        </p:nvSpPr>
        <p:spPr>
          <a:xfrm>
            <a:off x="2592360" y="6143760"/>
            <a:ext cx="695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sylvestris 674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Line 644"/>
          <p:cNvSpPr/>
          <p:nvPr/>
        </p:nvSpPr>
        <p:spPr>
          <a:xfrm flipH="1">
            <a:off x="2426760" y="6332400"/>
            <a:ext cx="2098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645"/>
          <p:cNvSpPr/>
          <p:nvPr/>
        </p:nvSpPr>
        <p:spPr>
          <a:xfrm>
            <a:off x="2692440" y="6253200"/>
            <a:ext cx="695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sylvestris 911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Line 646"/>
          <p:cNvSpPr/>
          <p:nvPr/>
        </p:nvSpPr>
        <p:spPr>
          <a:xfrm flipH="1">
            <a:off x="2427120" y="6453360"/>
            <a:ext cx="1000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ectangle 647"/>
          <p:cNvSpPr/>
          <p:nvPr/>
        </p:nvSpPr>
        <p:spPr>
          <a:xfrm>
            <a:off x="2583000" y="6373800"/>
            <a:ext cx="695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sylvestris 911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Line 648"/>
          <p:cNvSpPr/>
          <p:nvPr/>
        </p:nvSpPr>
        <p:spPr>
          <a:xfrm flipH="1">
            <a:off x="2426760" y="6562800"/>
            <a:ext cx="1098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Rectangle 649"/>
          <p:cNvSpPr/>
          <p:nvPr/>
        </p:nvSpPr>
        <p:spPr>
          <a:xfrm>
            <a:off x="2592360" y="6492960"/>
            <a:ext cx="805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sylvestris TG 31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Line 650"/>
          <p:cNvSpPr/>
          <p:nvPr/>
        </p:nvSpPr>
        <p:spPr>
          <a:xfrm flipH="1">
            <a:off x="1797120" y="5862600"/>
            <a:ext cx="6746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Line 651"/>
          <p:cNvSpPr/>
          <p:nvPr/>
        </p:nvSpPr>
        <p:spPr>
          <a:xfrm flipH="1">
            <a:off x="1797120" y="5743440"/>
            <a:ext cx="3506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Line 652"/>
          <p:cNvSpPr/>
          <p:nvPr/>
        </p:nvSpPr>
        <p:spPr>
          <a:xfrm flipH="1">
            <a:off x="2226960" y="6683400"/>
            <a:ext cx="1206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Rectangle 653"/>
          <p:cNvSpPr/>
          <p:nvPr/>
        </p:nvSpPr>
        <p:spPr>
          <a:xfrm>
            <a:off x="2399760" y="6602400"/>
            <a:ext cx="973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gratianopolitanus 33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Line 654"/>
          <p:cNvSpPr/>
          <p:nvPr/>
        </p:nvSpPr>
        <p:spPr>
          <a:xfrm flipH="1">
            <a:off x="2226960" y="6802560"/>
            <a:ext cx="1112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Rectangle 655"/>
          <p:cNvSpPr/>
          <p:nvPr/>
        </p:nvSpPr>
        <p:spPr>
          <a:xfrm>
            <a:off x="2389680" y="6723000"/>
            <a:ext cx="1015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gratianopolitanus Dg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tangle 656"/>
          <p:cNvSpPr/>
          <p:nvPr/>
        </p:nvSpPr>
        <p:spPr>
          <a:xfrm>
            <a:off x="2609280" y="6843600"/>
            <a:ext cx="973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gratianopolitanus 33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Rectangle 657"/>
          <p:cNvSpPr/>
          <p:nvPr/>
        </p:nvSpPr>
        <p:spPr>
          <a:xfrm>
            <a:off x="2608560" y="6953400"/>
            <a:ext cx="1134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gratianopolitanus TG 33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Rectangle 658"/>
          <p:cNvSpPr/>
          <p:nvPr/>
        </p:nvSpPr>
        <p:spPr>
          <a:xfrm>
            <a:off x="2952000" y="7074000"/>
            <a:ext cx="672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superbus 871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Line 659"/>
          <p:cNvSpPr/>
          <p:nvPr/>
        </p:nvSpPr>
        <p:spPr>
          <a:xfrm flipH="1">
            <a:off x="2650680" y="7153200"/>
            <a:ext cx="2206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Line 660"/>
          <p:cNvSpPr/>
          <p:nvPr/>
        </p:nvSpPr>
        <p:spPr>
          <a:xfrm flipH="1">
            <a:off x="2227320" y="6913440"/>
            <a:ext cx="1094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Line 661"/>
          <p:cNvSpPr/>
          <p:nvPr/>
        </p:nvSpPr>
        <p:spPr>
          <a:xfrm flipH="1">
            <a:off x="2227320" y="7032600"/>
            <a:ext cx="1094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Line 662"/>
          <p:cNvSpPr/>
          <p:nvPr/>
        </p:nvSpPr>
        <p:spPr>
          <a:xfrm flipH="1">
            <a:off x="2226960" y="7153200"/>
            <a:ext cx="4395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Line 663"/>
          <p:cNvSpPr/>
          <p:nvPr/>
        </p:nvSpPr>
        <p:spPr>
          <a:xfrm>
            <a:off x="2227320" y="6913440"/>
            <a:ext cx="1440" cy="2397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Rectangle 664"/>
          <p:cNvSpPr/>
          <p:nvPr/>
        </p:nvSpPr>
        <p:spPr>
          <a:xfrm>
            <a:off x="2610360" y="7192800"/>
            <a:ext cx="1027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monspessulanus 1291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Rectangle 665"/>
          <p:cNvSpPr/>
          <p:nvPr/>
        </p:nvSpPr>
        <p:spPr>
          <a:xfrm>
            <a:off x="2610360" y="7313760"/>
            <a:ext cx="1027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monspessulanus 129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Rectangle 666"/>
          <p:cNvSpPr/>
          <p:nvPr/>
        </p:nvSpPr>
        <p:spPr>
          <a:xfrm>
            <a:off x="2620440" y="7423200"/>
            <a:ext cx="1085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monspessulanus TG 3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Rectangle 667"/>
          <p:cNvSpPr/>
          <p:nvPr/>
        </p:nvSpPr>
        <p:spPr>
          <a:xfrm>
            <a:off x="2610720" y="7543800"/>
            <a:ext cx="1085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monspessulanus TG 3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Rectangle 668"/>
          <p:cNvSpPr/>
          <p:nvPr/>
        </p:nvSpPr>
        <p:spPr>
          <a:xfrm>
            <a:off x="2620440" y="7662960"/>
            <a:ext cx="1085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monspessulanus TG 32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Rectangle 669"/>
          <p:cNvSpPr/>
          <p:nvPr/>
        </p:nvSpPr>
        <p:spPr>
          <a:xfrm>
            <a:off x="2622240" y="7773840"/>
            <a:ext cx="805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sylvestris TG 33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Line 670"/>
          <p:cNvSpPr/>
          <p:nvPr/>
        </p:nvSpPr>
        <p:spPr>
          <a:xfrm flipH="1">
            <a:off x="2327040" y="7273800"/>
            <a:ext cx="2206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Line 671"/>
          <p:cNvSpPr/>
          <p:nvPr/>
        </p:nvSpPr>
        <p:spPr>
          <a:xfrm flipH="1">
            <a:off x="2227320" y="7273800"/>
            <a:ext cx="1094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Line 672"/>
          <p:cNvSpPr/>
          <p:nvPr/>
        </p:nvSpPr>
        <p:spPr>
          <a:xfrm flipH="1">
            <a:off x="2227320" y="7383600"/>
            <a:ext cx="1094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Line 673"/>
          <p:cNvSpPr/>
          <p:nvPr/>
        </p:nvSpPr>
        <p:spPr>
          <a:xfrm flipH="1">
            <a:off x="2227320" y="7502400"/>
            <a:ext cx="1094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Line 674"/>
          <p:cNvSpPr/>
          <p:nvPr/>
        </p:nvSpPr>
        <p:spPr>
          <a:xfrm flipH="1">
            <a:off x="2227320" y="7623000"/>
            <a:ext cx="1094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Line 675"/>
          <p:cNvSpPr/>
          <p:nvPr/>
        </p:nvSpPr>
        <p:spPr>
          <a:xfrm flipH="1">
            <a:off x="2227320" y="7732800"/>
            <a:ext cx="1094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Line 676"/>
          <p:cNvSpPr/>
          <p:nvPr/>
        </p:nvSpPr>
        <p:spPr>
          <a:xfrm flipH="1">
            <a:off x="2227320" y="7853400"/>
            <a:ext cx="1094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Line 677"/>
          <p:cNvSpPr/>
          <p:nvPr/>
        </p:nvSpPr>
        <p:spPr>
          <a:xfrm>
            <a:off x="2227320" y="7273800"/>
            <a:ext cx="1440" cy="5796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Line 678"/>
          <p:cNvSpPr/>
          <p:nvPr/>
        </p:nvSpPr>
        <p:spPr>
          <a:xfrm flipH="1">
            <a:off x="1796760" y="7153200"/>
            <a:ext cx="4302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Line 679"/>
          <p:cNvSpPr/>
          <p:nvPr/>
        </p:nvSpPr>
        <p:spPr>
          <a:xfrm>
            <a:off x="2227320" y="6683400"/>
            <a:ext cx="1440" cy="8794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Rectangle 680"/>
          <p:cNvSpPr/>
          <p:nvPr/>
        </p:nvSpPr>
        <p:spPr>
          <a:xfrm>
            <a:off x="1243440" y="7020000"/>
            <a:ext cx="447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0.97/86/9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Line 681"/>
          <p:cNvSpPr/>
          <p:nvPr/>
        </p:nvSpPr>
        <p:spPr>
          <a:xfrm flipH="1">
            <a:off x="1287360" y="7153200"/>
            <a:ext cx="5097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Line 682"/>
          <p:cNvSpPr/>
          <p:nvPr/>
        </p:nvSpPr>
        <p:spPr>
          <a:xfrm flipH="1">
            <a:off x="1957320" y="7972560"/>
            <a:ext cx="1094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Rectangle 683"/>
          <p:cNvSpPr/>
          <p:nvPr/>
        </p:nvSpPr>
        <p:spPr>
          <a:xfrm>
            <a:off x="2120040" y="7893000"/>
            <a:ext cx="1005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carthusianorum TG 6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Line 684"/>
          <p:cNvSpPr/>
          <p:nvPr/>
        </p:nvSpPr>
        <p:spPr>
          <a:xfrm flipH="1">
            <a:off x="1956960" y="8083440"/>
            <a:ext cx="4208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Rectangle 685"/>
          <p:cNvSpPr/>
          <p:nvPr/>
        </p:nvSpPr>
        <p:spPr>
          <a:xfrm>
            <a:off x="2432160" y="8013600"/>
            <a:ext cx="630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Grepens Gr13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Line 686"/>
          <p:cNvSpPr/>
          <p:nvPr/>
        </p:nvSpPr>
        <p:spPr>
          <a:xfrm flipH="1">
            <a:off x="2417400" y="8202600"/>
            <a:ext cx="2300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Rectangle 687"/>
          <p:cNvSpPr/>
          <p:nvPr/>
        </p:nvSpPr>
        <p:spPr>
          <a:xfrm>
            <a:off x="2700360" y="8132760"/>
            <a:ext cx="999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carthusianorum 309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Line 688"/>
          <p:cNvSpPr/>
          <p:nvPr/>
        </p:nvSpPr>
        <p:spPr>
          <a:xfrm flipH="1">
            <a:off x="2417760" y="8323200"/>
            <a:ext cx="2397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Rectangle 689"/>
          <p:cNvSpPr/>
          <p:nvPr/>
        </p:nvSpPr>
        <p:spPr>
          <a:xfrm>
            <a:off x="2709720" y="8244000"/>
            <a:ext cx="999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carthusianorum 309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Line 690"/>
          <p:cNvSpPr/>
          <p:nvPr/>
        </p:nvSpPr>
        <p:spPr>
          <a:xfrm flipH="1">
            <a:off x="2417400" y="8432640"/>
            <a:ext cx="1191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Rectangle 691"/>
          <p:cNvSpPr/>
          <p:nvPr/>
        </p:nvSpPr>
        <p:spPr>
          <a:xfrm>
            <a:off x="2589120" y="8362800"/>
            <a:ext cx="999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carthusianorum 316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Line 692"/>
          <p:cNvSpPr/>
          <p:nvPr/>
        </p:nvSpPr>
        <p:spPr>
          <a:xfrm flipH="1">
            <a:off x="2417760" y="8553600"/>
            <a:ext cx="2095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Rectangle 693"/>
          <p:cNvSpPr/>
          <p:nvPr/>
        </p:nvSpPr>
        <p:spPr>
          <a:xfrm>
            <a:off x="2689920" y="8483760"/>
            <a:ext cx="1005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carthusianorum TG 6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Line 694"/>
          <p:cNvSpPr/>
          <p:nvPr/>
        </p:nvSpPr>
        <p:spPr>
          <a:xfrm flipH="1">
            <a:off x="2417760" y="8672400"/>
            <a:ext cx="1094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Rectangle 695"/>
          <p:cNvSpPr/>
          <p:nvPr/>
        </p:nvSpPr>
        <p:spPr>
          <a:xfrm>
            <a:off x="2580480" y="8593200"/>
            <a:ext cx="1005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carthusianorum TG 6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Line 696"/>
          <p:cNvSpPr/>
          <p:nvPr/>
        </p:nvSpPr>
        <p:spPr>
          <a:xfrm flipH="1">
            <a:off x="2417760" y="8793000"/>
            <a:ext cx="1094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Rectangle 697"/>
          <p:cNvSpPr/>
          <p:nvPr/>
        </p:nvSpPr>
        <p:spPr>
          <a:xfrm>
            <a:off x="2584080" y="8713800"/>
            <a:ext cx="526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Grepens Gr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Line 698"/>
          <p:cNvSpPr/>
          <p:nvPr/>
        </p:nvSpPr>
        <p:spPr>
          <a:xfrm flipH="1">
            <a:off x="1956960" y="8493120"/>
            <a:ext cx="4604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Line 699"/>
          <p:cNvSpPr/>
          <p:nvPr/>
        </p:nvSpPr>
        <p:spPr>
          <a:xfrm>
            <a:off x="2417760" y="8202600"/>
            <a:ext cx="1440" cy="5904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Rectangle 700"/>
          <p:cNvSpPr/>
          <p:nvPr/>
        </p:nvSpPr>
        <p:spPr>
          <a:xfrm>
            <a:off x="1962720" y="8352000"/>
            <a:ext cx="447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94/9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Line 701"/>
          <p:cNvSpPr/>
          <p:nvPr/>
        </p:nvSpPr>
        <p:spPr>
          <a:xfrm flipH="1">
            <a:off x="1287000" y="8232840"/>
            <a:ext cx="6699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Line 702"/>
          <p:cNvSpPr/>
          <p:nvPr/>
        </p:nvSpPr>
        <p:spPr>
          <a:xfrm>
            <a:off x="1957320" y="7972560"/>
            <a:ext cx="1800" cy="520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Rectangle 703"/>
          <p:cNvSpPr/>
          <p:nvPr/>
        </p:nvSpPr>
        <p:spPr>
          <a:xfrm>
            <a:off x="1386360" y="8101080"/>
            <a:ext cx="447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97/9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Line 704"/>
          <p:cNvSpPr/>
          <p:nvPr/>
        </p:nvSpPr>
        <p:spPr>
          <a:xfrm flipH="1">
            <a:off x="887040" y="8232840"/>
            <a:ext cx="3999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Line 705"/>
          <p:cNvSpPr/>
          <p:nvPr/>
        </p:nvSpPr>
        <p:spPr>
          <a:xfrm>
            <a:off x="477720" y="6553080"/>
            <a:ext cx="1800" cy="16797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Line 706"/>
          <p:cNvSpPr/>
          <p:nvPr/>
        </p:nvSpPr>
        <p:spPr>
          <a:xfrm flipH="1">
            <a:off x="477720" y="1116000"/>
            <a:ext cx="4096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Line 707"/>
          <p:cNvSpPr/>
          <p:nvPr/>
        </p:nvSpPr>
        <p:spPr>
          <a:xfrm>
            <a:off x="477720" y="2592360"/>
            <a:ext cx="18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Line 708"/>
          <p:cNvSpPr/>
          <p:nvPr/>
        </p:nvSpPr>
        <p:spPr>
          <a:xfrm>
            <a:off x="477720" y="493560"/>
            <a:ext cx="1800" cy="7740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Line 709"/>
          <p:cNvSpPr/>
          <p:nvPr/>
        </p:nvSpPr>
        <p:spPr>
          <a:xfrm flipH="1">
            <a:off x="115920" y="755640"/>
            <a:ext cx="3636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Line 710"/>
          <p:cNvSpPr/>
          <p:nvPr/>
        </p:nvSpPr>
        <p:spPr>
          <a:xfrm flipH="1">
            <a:off x="2039760" y="3916440"/>
            <a:ext cx="2304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Line 711"/>
          <p:cNvSpPr/>
          <p:nvPr/>
        </p:nvSpPr>
        <p:spPr>
          <a:xfrm flipH="1">
            <a:off x="2039760" y="4033800"/>
            <a:ext cx="2304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Line 712"/>
          <p:cNvSpPr/>
          <p:nvPr/>
        </p:nvSpPr>
        <p:spPr>
          <a:xfrm flipH="1">
            <a:off x="1707840" y="3916440"/>
            <a:ext cx="2300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Line 713"/>
          <p:cNvSpPr/>
          <p:nvPr/>
        </p:nvSpPr>
        <p:spPr>
          <a:xfrm flipH="1">
            <a:off x="1707840" y="3794040"/>
            <a:ext cx="2300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Line 714"/>
          <p:cNvSpPr/>
          <p:nvPr/>
        </p:nvSpPr>
        <p:spPr>
          <a:xfrm flipH="1">
            <a:off x="1707840" y="3662280"/>
            <a:ext cx="2300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Line 715"/>
          <p:cNvSpPr/>
          <p:nvPr/>
        </p:nvSpPr>
        <p:spPr>
          <a:xfrm flipH="1">
            <a:off x="1707840" y="3538440"/>
            <a:ext cx="2300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Rectangle 716"/>
          <p:cNvSpPr/>
          <p:nvPr/>
        </p:nvSpPr>
        <p:spPr>
          <a:xfrm>
            <a:off x="4337640" y="3081240"/>
            <a:ext cx="663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latifolia 100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Rectangle 717"/>
          <p:cNvSpPr/>
          <p:nvPr/>
        </p:nvSpPr>
        <p:spPr>
          <a:xfrm>
            <a:off x="4205160" y="3201840"/>
            <a:ext cx="612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latifolia 40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Rectangle 718"/>
          <p:cNvSpPr/>
          <p:nvPr/>
        </p:nvSpPr>
        <p:spPr>
          <a:xfrm>
            <a:off x="4194000" y="3322800"/>
            <a:ext cx="612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latifolia 41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Rectangle 719"/>
          <p:cNvSpPr/>
          <p:nvPr/>
        </p:nvSpPr>
        <p:spPr>
          <a:xfrm>
            <a:off x="4206600" y="3441600"/>
            <a:ext cx="524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latifolia sl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Line 720"/>
          <p:cNvSpPr/>
          <p:nvPr/>
        </p:nvSpPr>
        <p:spPr>
          <a:xfrm>
            <a:off x="3817800" y="2451240"/>
            <a:ext cx="1800" cy="7585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Line 721"/>
          <p:cNvSpPr/>
          <p:nvPr/>
        </p:nvSpPr>
        <p:spPr>
          <a:xfrm flipH="1">
            <a:off x="3817440" y="2914560"/>
            <a:ext cx="1112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Line 722"/>
          <p:cNvSpPr/>
          <p:nvPr/>
        </p:nvSpPr>
        <p:spPr>
          <a:xfrm flipH="1">
            <a:off x="3817800" y="3057480"/>
            <a:ext cx="1209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Line 723"/>
          <p:cNvSpPr/>
          <p:nvPr/>
        </p:nvSpPr>
        <p:spPr>
          <a:xfrm flipH="1">
            <a:off x="3817440" y="3162240"/>
            <a:ext cx="2206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Line 724"/>
          <p:cNvSpPr/>
          <p:nvPr/>
        </p:nvSpPr>
        <p:spPr>
          <a:xfrm flipH="1">
            <a:off x="3817440" y="3281400"/>
            <a:ext cx="1112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Line 725"/>
          <p:cNvSpPr/>
          <p:nvPr/>
        </p:nvSpPr>
        <p:spPr>
          <a:xfrm flipH="1">
            <a:off x="3817440" y="3402000"/>
            <a:ext cx="1112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Line 726"/>
          <p:cNvSpPr/>
          <p:nvPr/>
        </p:nvSpPr>
        <p:spPr>
          <a:xfrm>
            <a:off x="3817800" y="2903400"/>
            <a:ext cx="1800" cy="5889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Line 727"/>
          <p:cNvSpPr/>
          <p:nvPr/>
        </p:nvSpPr>
        <p:spPr>
          <a:xfrm flipH="1">
            <a:off x="3943440" y="2914560"/>
            <a:ext cx="2188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Line 728"/>
          <p:cNvSpPr/>
          <p:nvPr/>
        </p:nvSpPr>
        <p:spPr>
          <a:xfrm flipH="1">
            <a:off x="3908520" y="3057480"/>
            <a:ext cx="2188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Line 729"/>
          <p:cNvSpPr/>
          <p:nvPr/>
        </p:nvSpPr>
        <p:spPr>
          <a:xfrm flipH="1">
            <a:off x="4052520" y="3162240"/>
            <a:ext cx="2192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Line 730"/>
          <p:cNvSpPr/>
          <p:nvPr/>
        </p:nvSpPr>
        <p:spPr>
          <a:xfrm flipH="1">
            <a:off x="3908520" y="3281400"/>
            <a:ext cx="2188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Line 731"/>
          <p:cNvSpPr/>
          <p:nvPr/>
        </p:nvSpPr>
        <p:spPr>
          <a:xfrm flipH="1">
            <a:off x="3908520" y="3402000"/>
            <a:ext cx="2188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Line 732"/>
          <p:cNvSpPr/>
          <p:nvPr/>
        </p:nvSpPr>
        <p:spPr>
          <a:xfrm flipH="1">
            <a:off x="2166480" y="1257480"/>
            <a:ext cx="56052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Rectangle 733"/>
          <p:cNvSpPr/>
          <p:nvPr/>
        </p:nvSpPr>
        <p:spPr>
          <a:xfrm>
            <a:off x="2795040" y="1187280"/>
            <a:ext cx="451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lemmoni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Line 734"/>
          <p:cNvSpPr/>
          <p:nvPr/>
        </p:nvSpPr>
        <p:spPr>
          <a:xfrm flipH="1">
            <a:off x="2408040" y="1376280"/>
            <a:ext cx="5792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Rectangle 735"/>
          <p:cNvSpPr/>
          <p:nvPr/>
        </p:nvSpPr>
        <p:spPr>
          <a:xfrm>
            <a:off x="3045960" y="1297080"/>
            <a:ext cx="473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otites Sot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Line 736"/>
          <p:cNvSpPr/>
          <p:nvPr/>
        </p:nvSpPr>
        <p:spPr>
          <a:xfrm flipH="1">
            <a:off x="3677760" y="1496880"/>
            <a:ext cx="2192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Rectangle 737"/>
          <p:cNvSpPr/>
          <p:nvPr/>
        </p:nvSpPr>
        <p:spPr>
          <a:xfrm>
            <a:off x="3951360" y="1417680"/>
            <a:ext cx="703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Lflos cuculi92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Line 738"/>
          <p:cNvSpPr/>
          <p:nvPr/>
        </p:nvSpPr>
        <p:spPr>
          <a:xfrm flipH="1">
            <a:off x="3677760" y="1606680"/>
            <a:ext cx="1098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Rectangle 739"/>
          <p:cNvSpPr/>
          <p:nvPr/>
        </p:nvSpPr>
        <p:spPr>
          <a:xfrm>
            <a:off x="3850920" y="1536840"/>
            <a:ext cx="780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Lflos cuculi 1093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Line 740"/>
          <p:cNvSpPr/>
          <p:nvPr/>
        </p:nvSpPr>
        <p:spPr>
          <a:xfrm flipH="1">
            <a:off x="3119040" y="1546200"/>
            <a:ext cx="33012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Line 741"/>
          <p:cNvSpPr/>
          <p:nvPr/>
        </p:nvSpPr>
        <p:spPr>
          <a:xfrm>
            <a:off x="3678120" y="1496880"/>
            <a:ext cx="1800" cy="109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Rectangle 742"/>
          <p:cNvSpPr/>
          <p:nvPr/>
        </p:nvSpPr>
        <p:spPr>
          <a:xfrm>
            <a:off x="3186720" y="1558800"/>
            <a:ext cx="447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87/8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Line 743"/>
          <p:cNvSpPr/>
          <p:nvPr/>
        </p:nvSpPr>
        <p:spPr>
          <a:xfrm flipH="1">
            <a:off x="4506480" y="1727280"/>
            <a:ext cx="1112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Rectangle 744"/>
          <p:cNvSpPr/>
          <p:nvPr/>
        </p:nvSpPr>
        <p:spPr>
          <a:xfrm>
            <a:off x="4683240" y="1646280"/>
            <a:ext cx="560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nutans 79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Line 745"/>
          <p:cNvSpPr/>
          <p:nvPr/>
        </p:nvSpPr>
        <p:spPr>
          <a:xfrm flipH="1">
            <a:off x="4506480" y="1846440"/>
            <a:ext cx="1112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Rectangle 746"/>
          <p:cNvSpPr/>
          <p:nvPr/>
        </p:nvSpPr>
        <p:spPr>
          <a:xfrm>
            <a:off x="4672080" y="1766880"/>
            <a:ext cx="560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nutans 874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Line 747"/>
          <p:cNvSpPr/>
          <p:nvPr/>
        </p:nvSpPr>
        <p:spPr>
          <a:xfrm flipH="1">
            <a:off x="4506480" y="1957320"/>
            <a:ext cx="1112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Rectangle 748"/>
          <p:cNvSpPr/>
          <p:nvPr/>
        </p:nvSpPr>
        <p:spPr>
          <a:xfrm>
            <a:off x="4673520" y="1887480"/>
            <a:ext cx="466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nutans L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Line 749"/>
          <p:cNvSpPr/>
          <p:nvPr/>
        </p:nvSpPr>
        <p:spPr>
          <a:xfrm flipH="1">
            <a:off x="4506840" y="2076480"/>
            <a:ext cx="1000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Rectangle 750"/>
          <p:cNvSpPr/>
          <p:nvPr/>
        </p:nvSpPr>
        <p:spPr>
          <a:xfrm>
            <a:off x="4672080" y="1996920"/>
            <a:ext cx="669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nutans TG 30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Line 751"/>
          <p:cNvSpPr/>
          <p:nvPr/>
        </p:nvSpPr>
        <p:spPr>
          <a:xfrm flipH="1">
            <a:off x="3706920" y="1906560"/>
            <a:ext cx="7999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Line 752"/>
          <p:cNvSpPr/>
          <p:nvPr/>
        </p:nvSpPr>
        <p:spPr>
          <a:xfrm>
            <a:off x="4506840" y="1727280"/>
            <a:ext cx="1800" cy="349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Rectangle 753"/>
          <p:cNvSpPr/>
          <p:nvPr/>
        </p:nvSpPr>
        <p:spPr>
          <a:xfrm>
            <a:off x="3834720" y="1774800"/>
            <a:ext cx="550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100/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Rectangle 754"/>
          <p:cNvSpPr/>
          <p:nvPr/>
        </p:nvSpPr>
        <p:spPr>
          <a:xfrm>
            <a:off x="4113360" y="2116080"/>
            <a:ext cx="622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vulgaris 780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Rectangle 755"/>
          <p:cNvSpPr/>
          <p:nvPr/>
        </p:nvSpPr>
        <p:spPr>
          <a:xfrm>
            <a:off x="4102200" y="2236680"/>
            <a:ext cx="622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vulgaris 790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Line 756"/>
          <p:cNvSpPr/>
          <p:nvPr/>
        </p:nvSpPr>
        <p:spPr>
          <a:xfrm flipH="1">
            <a:off x="3706560" y="2197080"/>
            <a:ext cx="1299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Line 757"/>
          <p:cNvSpPr/>
          <p:nvPr/>
        </p:nvSpPr>
        <p:spPr>
          <a:xfrm flipH="1">
            <a:off x="3706560" y="2316240"/>
            <a:ext cx="1206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Line 758"/>
          <p:cNvSpPr/>
          <p:nvPr/>
        </p:nvSpPr>
        <p:spPr>
          <a:xfrm>
            <a:off x="3706920" y="2197080"/>
            <a:ext cx="1440" cy="119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Line 759"/>
          <p:cNvSpPr/>
          <p:nvPr/>
        </p:nvSpPr>
        <p:spPr>
          <a:xfrm flipH="1">
            <a:off x="3119040" y="2076480"/>
            <a:ext cx="35892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Line 760"/>
          <p:cNvSpPr/>
          <p:nvPr/>
        </p:nvSpPr>
        <p:spPr>
          <a:xfrm>
            <a:off x="3706920" y="1906560"/>
            <a:ext cx="1440" cy="3510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Rectangle 761"/>
          <p:cNvSpPr/>
          <p:nvPr/>
        </p:nvSpPr>
        <p:spPr>
          <a:xfrm>
            <a:off x="3186720" y="1954080"/>
            <a:ext cx="447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86/7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Line 762"/>
          <p:cNvSpPr/>
          <p:nvPr/>
        </p:nvSpPr>
        <p:spPr>
          <a:xfrm flipH="1">
            <a:off x="3443040" y="1546200"/>
            <a:ext cx="2300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Line 763"/>
          <p:cNvSpPr/>
          <p:nvPr/>
        </p:nvSpPr>
        <p:spPr>
          <a:xfrm>
            <a:off x="3119400" y="1546200"/>
            <a:ext cx="1800" cy="5302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Line 764"/>
          <p:cNvSpPr/>
          <p:nvPr/>
        </p:nvSpPr>
        <p:spPr>
          <a:xfrm flipH="1">
            <a:off x="3817800" y="2427120"/>
            <a:ext cx="5889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Rectangle 765"/>
          <p:cNvSpPr/>
          <p:nvPr/>
        </p:nvSpPr>
        <p:spPr>
          <a:xfrm>
            <a:off x="4462560" y="2357280"/>
            <a:ext cx="543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dioica 721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Line 766"/>
          <p:cNvSpPr/>
          <p:nvPr/>
        </p:nvSpPr>
        <p:spPr>
          <a:xfrm flipH="1">
            <a:off x="3817440" y="2546280"/>
            <a:ext cx="1098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Rectangle 767"/>
          <p:cNvSpPr/>
          <p:nvPr/>
        </p:nvSpPr>
        <p:spPr>
          <a:xfrm>
            <a:off x="3983040" y="2478240"/>
            <a:ext cx="543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dioica 723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Line 768"/>
          <p:cNvSpPr/>
          <p:nvPr/>
        </p:nvSpPr>
        <p:spPr>
          <a:xfrm flipH="1">
            <a:off x="3817440" y="2666880"/>
            <a:ext cx="1098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Rectangle 769"/>
          <p:cNvSpPr/>
          <p:nvPr/>
        </p:nvSpPr>
        <p:spPr>
          <a:xfrm>
            <a:off x="3984120" y="2598840"/>
            <a:ext cx="496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dioica Sd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Line 770"/>
          <p:cNvSpPr/>
          <p:nvPr/>
        </p:nvSpPr>
        <p:spPr>
          <a:xfrm flipH="1">
            <a:off x="3817440" y="2776680"/>
            <a:ext cx="1098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Rectangle 771"/>
          <p:cNvSpPr/>
          <p:nvPr/>
        </p:nvSpPr>
        <p:spPr>
          <a:xfrm>
            <a:off x="4232880" y="2840040"/>
            <a:ext cx="764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ocymoides soc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Rectangle 772"/>
          <p:cNvSpPr/>
          <p:nvPr/>
        </p:nvSpPr>
        <p:spPr>
          <a:xfrm>
            <a:off x="4204440" y="2960640"/>
            <a:ext cx="663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latifolia 100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Line 773"/>
          <p:cNvSpPr/>
          <p:nvPr/>
        </p:nvSpPr>
        <p:spPr>
          <a:xfrm flipH="1">
            <a:off x="3117960" y="2806560"/>
            <a:ext cx="6998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Rectangle 774"/>
          <p:cNvSpPr/>
          <p:nvPr/>
        </p:nvSpPr>
        <p:spPr>
          <a:xfrm>
            <a:off x="3259080" y="2673360"/>
            <a:ext cx="498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99/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Line 775"/>
          <p:cNvSpPr/>
          <p:nvPr/>
        </p:nvSpPr>
        <p:spPr>
          <a:xfrm flipH="1">
            <a:off x="2408040" y="2306520"/>
            <a:ext cx="7095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Line 776"/>
          <p:cNvSpPr/>
          <p:nvPr/>
        </p:nvSpPr>
        <p:spPr>
          <a:xfrm>
            <a:off x="3117960" y="1816200"/>
            <a:ext cx="1440" cy="9903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Rectangle 777"/>
          <p:cNvSpPr/>
          <p:nvPr/>
        </p:nvSpPr>
        <p:spPr>
          <a:xfrm>
            <a:off x="2178360" y="2195640"/>
            <a:ext cx="447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96/9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Line 778"/>
          <p:cNvSpPr/>
          <p:nvPr/>
        </p:nvSpPr>
        <p:spPr>
          <a:xfrm flipH="1">
            <a:off x="2182320" y="1376280"/>
            <a:ext cx="2415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Line 779"/>
          <p:cNvSpPr/>
          <p:nvPr/>
        </p:nvSpPr>
        <p:spPr>
          <a:xfrm>
            <a:off x="1708200" y="1257480"/>
            <a:ext cx="1440" cy="5889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Line 780"/>
          <p:cNvSpPr/>
          <p:nvPr/>
        </p:nvSpPr>
        <p:spPr>
          <a:xfrm flipH="1">
            <a:off x="3839760" y="2197080"/>
            <a:ext cx="2206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Line 781"/>
          <p:cNvSpPr/>
          <p:nvPr/>
        </p:nvSpPr>
        <p:spPr>
          <a:xfrm flipH="1">
            <a:off x="3839760" y="2316240"/>
            <a:ext cx="2206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Line 782"/>
          <p:cNvSpPr/>
          <p:nvPr/>
        </p:nvSpPr>
        <p:spPr>
          <a:xfrm flipH="1">
            <a:off x="3479760" y="2076480"/>
            <a:ext cx="2304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Line 783"/>
          <p:cNvSpPr/>
          <p:nvPr/>
        </p:nvSpPr>
        <p:spPr>
          <a:xfrm flipH="1">
            <a:off x="2166840" y="2306520"/>
            <a:ext cx="2304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80" name="Group 784"/>
          <p:cNvGrpSpPr/>
          <p:nvPr/>
        </p:nvGrpSpPr>
        <p:grpSpPr>
          <a:xfrm>
            <a:off x="1707840" y="2306520"/>
            <a:ext cx="458640" cy="1440"/>
            <a:chOff x="1707840" y="2306520"/>
            <a:chExt cx="458640" cy="1440"/>
          </a:xfrm>
        </p:grpSpPr>
        <p:sp>
          <p:nvSpPr>
            <p:cNvPr id="281" name="Line 785"/>
            <p:cNvSpPr/>
            <p:nvPr/>
          </p:nvSpPr>
          <p:spPr>
            <a:xfrm flipH="1">
              <a:off x="1937880" y="2306520"/>
              <a:ext cx="22860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Line 786"/>
            <p:cNvSpPr/>
            <p:nvPr/>
          </p:nvSpPr>
          <p:spPr>
            <a:xfrm flipH="1">
              <a:off x="1707840" y="2306520"/>
              <a:ext cx="23004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83" name="Group 787"/>
          <p:cNvGrpSpPr/>
          <p:nvPr/>
        </p:nvGrpSpPr>
        <p:grpSpPr>
          <a:xfrm>
            <a:off x="1707840" y="1258920"/>
            <a:ext cx="458640" cy="1440"/>
            <a:chOff x="1707840" y="1258920"/>
            <a:chExt cx="458640" cy="1440"/>
          </a:xfrm>
        </p:grpSpPr>
        <p:sp>
          <p:nvSpPr>
            <p:cNvPr id="284" name="Line 788"/>
            <p:cNvSpPr/>
            <p:nvPr/>
          </p:nvSpPr>
          <p:spPr>
            <a:xfrm flipH="1">
              <a:off x="1937880" y="1258920"/>
              <a:ext cx="22860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Line 789"/>
            <p:cNvSpPr/>
            <p:nvPr/>
          </p:nvSpPr>
          <p:spPr>
            <a:xfrm flipH="1">
              <a:off x="1707840" y="1258920"/>
              <a:ext cx="23004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86" name="Group 790"/>
          <p:cNvGrpSpPr/>
          <p:nvPr/>
        </p:nvGrpSpPr>
        <p:grpSpPr>
          <a:xfrm>
            <a:off x="1707840" y="1376280"/>
            <a:ext cx="458640" cy="1440"/>
            <a:chOff x="1707840" y="1376280"/>
            <a:chExt cx="458640" cy="1440"/>
          </a:xfrm>
        </p:grpSpPr>
        <p:sp>
          <p:nvSpPr>
            <p:cNvPr id="287" name="Line 791"/>
            <p:cNvSpPr/>
            <p:nvPr/>
          </p:nvSpPr>
          <p:spPr>
            <a:xfrm flipH="1">
              <a:off x="1937880" y="1376280"/>
              <a:ext cx="22860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Line 792"/>
            <p:cNvSpPr/>
            <p:nvPr/>
          </p:nvSpPr>
          <p:spPr>
            <a:xfrm flipH="1">
              <a:off x="1707840" y="1376280"/>
              <a:ext cx="23004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89" name="Line 793"/>
          <p:cNvSpPr/>
          <p:nvPr/>
        </p:nvSpPr>
        <p:spPr>
          <a:xfrm flipH="1">
            <a:off x="2327040" y="7853400"/>
            <a:ext cx="2206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Line 794"/>
          <p:cNvSpPr/>
          <p:nvPr/>
        </p:nvSpPr>
        <p:spPr>
          <a:xfrm flipH="1">
            <a:off x="2327040" y="7383600"/>
            <a:ext cx="2206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Line 795"/>
          <p:cNvSpPr/>
          <p:nvPr/>
        </p:nvSpPr>
        <p:spPr>
          <a:xfrm flipH="1">
            <a:off x="2327040" y="7502400"/>
            <a:ext cx="2206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Line 796"/>
          <p:cNvSpPr/>
          <p:nvPr/>
        </p:nvSpPr>
        <p:spPr>
          <a:xfrm flipH="1">
            <a:off x="2327040" y="7623000"/>
            <a:ext cx="2206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Line 797"/>
          <p:cNvSpPr/>
          <p:nvPr/>
        </p:nvSpPr>
        <p:spPr>
          <a:xfrm flipH="1">
            <a:off x="2327040" y="7732800"/>
            <a:ext cx="2206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Line 798"/>
          <p:cNvSpPr/>
          <p:nvPr/>
        </p:nvSpPr>
        <p:spPr>
          <a:xfrm flipH="1">
            <a:off x="2327040" y="6913440"/>
            <a:ext cx="2206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Line 799"/>
          <p:cNvSpPr/>
          <p:nvPr/>
        </p:nvSpPr>
        <p:spPr>
          <a:xfrm flipH="1">
            <a:off x="2327040" y="7032600"/>
            <a:ext cx="2206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Line 800"/>
          <p:cNvSpPr/>
          <p:nvPr/>
        </p:nvSpPr>
        <p:spPr>
          <a:xfrm flipH="1">
            <a:off x="1797120" y="5983200"/>
            <a:ext cx="6746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Line 801"/>
          <p:cNvSpPr/>
          <p:nvPr/>
        </p:nvSpPr>
        <p:spPr>
          <a:xfrm flipH="1">
            <a:off x="1797120" y="6103800"/>
            <a:ext cx="6746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Line 802"/>
          <p:cNvSpPr/>
          <p:nvPr/>
        </p:nvSpPr>
        <p:spPr>
          <a:xfrm flipH="1">
            <a:off x="1797120" y="6213600"/>
            <a:ext cx="6746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Line 803"/>
          <p:cNvSpPr/>
          <p:nvPr/>
        </p:nvSpPr>
        <p:spPr>
          <a:xfrm flipH="1">
            <a:off x="1797120" y="6332400"/>
            <a:ext cx="6746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Line 804"/>
          <p:cNvSpPr/>
          <p:nvPr/>
        </p:nvSpPr>
        <p:spPr>
          <a:xfrm flipH="1">
            <a:off x="1797120" y="6453360"/>
            <a:ext cx="6746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Line 805"/>
          <p:cNvSpPr/>
          <p:nvPr/>
        </p:nvSpPr>
        <p:spPr>
          <a:xfrm flipH="1">
            <a:off x="1797120" y="6562800"/>
            <a:ext cx="6746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Line 806"/>
          <p:cNvSpPr/>
          <p:nvPr/>
        </p:nvSpPr>
        <p:spPr>
          <a:xfrm flipH="1">
            <a:off x="1287360" y="5743440"/>
            <a:ext cx="5097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Line 807"/>
          <p:cNvSpPr/>
          <p:nvPr/>
        </p:nvSpPr>
        <p:spPr>
          <a:xfrm flipH="1">
            <a:off x="1287360" y="5862600"/>
            <a:ext cx="5097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Line 808"/>
          <p:cNvSpPr/>
          <p:nvPr/>
        </p:nvSpPr>
        <p:spPr>
          <a:xfrm flipH="1">
            <a:off x="1287360" y="5983200"/>
            <a:ext cx="5097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Line 809"/>
          <p:cNvSpPr/>
          <p:nvPr/>
        </p:nvSpPr>
        <p:spPr>
          <a:xfrm flipH="1">
            <a:off x="1287360" y="6103800"/>
            <a:ext cx="5097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Line 810"/>
          <p:cNvSpPr/>
          <p:nvPr/>
        </p:nvSpPr>
        <p:spPr>
          <a:xfrm flipH="1">
            <a:off x="1287360" y="6213600"/>
            <a:ext cx="5097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Line 811"/>
          <p:cNvSpPr/>
          <p:nvPr/>
        </p:nvSpPr>
        <p:spPr>
          <a:xfrm flipH="1">
            <a:off x="1287360" y="6332400"/>
            <a:ext cx="5097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Line 812"/>
          <p:cNvSpPr/>
          <p:nvPr/>
        </p:nvSpPr>
        <p:spPr>
          <a:xfrm flipH="1">
            <a:off x="1287360" y="6453360"/>
            <a:ext cx="5097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Line 813"/>
          <p:cNvSpPr/>
          <p:nvPr/>
        </p:nvSpPr>
        <p:spPr>
          <a:xfrm flipH="1">
            <a:off x="1287360" y="6562800"/>
            <a:ext cx="5097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Line 814"/>
          <p:cNvSpPr/>
          <p:nvPr/>
        </p:nvSpPr>
        <p:spPr>
          <a:xfrm flipH="1">
            <a:off x="887040" y="7153200"/>
            <a:ext cx="3999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Line 815"/>
          <p:cNvSpPr/>
          <p:nvPr/>
        </p:nvSpPr>
        <p:spPr>
          <a:xfrm flipH="1">
            <a:off x="887040" y="6562800"/>
            <a:ext cx="3999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Line 816"/>
          <p:cNvSpPr/>
          <p:nvPr/>
        </p:nvSpPr>
        <p:spPr>
          <a:xfrm flipH="1">
            <a:off x="887040" y="6453360"/>
            <a:ext cx="3999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Line 817"/>
          <p:cNvSpPr/>
          <p:nvPr/>
        </p:nvSpPr>
        <p:spPr>
          <a:xfrm flipH="1">
            <a:off x="887040" y="6332400"/>
            <a:ext cx="3999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Line 818"/>
          <p:cNvSpPr/>
          <p:nvPr/>
        </p:nvSpPr>
        <p:spPr>
          <a:xfrm flipH="1">
            <a:off x="887040" y="6213600"/>
            <a:ext cx="3999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Line 819"/>
          <p:cNvSpPr/>
          <p:nvPr/>
        </p:nvSpPr>
        <p:spPr>
          <a:xfrm flipH="1">
            <a:off x="887040" y="6103800"/>
            <a:ext cx="3999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Line 820"/>
          <p:cNvSpPr/>
          <p:nvPr/>
        </p:nvSpPr>
        <p:spPr>
          <a:xfrm flipH="1">
            <a:off x="887040" y="5983200"/>
            <a:ext cx="3999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Line 821"/>
          <p:cNvSpPr/>
          <p:nvPr/>
        </p:nvSpPr>
        <p:spPr>
          <a:xfrm flipH="1">
            <a:off x="887040" y="5862600"/>
            <a:ext cx="3999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Line 822"/>
          <p:cNvSpPr/>
          <p:nvPr/>
        </p:nvSpPr>
        <p:spPr>
          <a:xfrm flipH="1">
            <a:off x="887040" y="5743440"/>
            <a:ext cx="3999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Line 823"/>
          <p:cNvSpPr/>
          <p:nvPr/>
        </p:nvSpPr>
        <p:spPr>
          <a:xfrm flipH="1">
            <a:off x="477720" y="1913040"/>
            <a:ext cx="4096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Line 824"/>
          <p:cNvSpPr/>
          <p:nvPr/>
        </p:nvSpPr>
        <p:spPr>
          <a:xfrm flipH="1">
            <a:off x="477720" y="4462560"/>
            <a:ext cx="4096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Line 825"/>
          <p:cNvSpPr/>
          <p:nvPr/>
        </p:nvSpPr>
        <p:spPr>
          <a:xfrm flipH="1">
            <a:off x="477720" y="5283360"/>
            <a:ext cx="4096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Line 826"/>
          <p:cNvSpPr/>
          <p:nvPr/>
        </p:nvSpPr>
        <p:spPr>
          <a:xfrm flipH="1">
            <a:off x="477720" y="5743440"/>
            <a:ext cx="4096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Line 827"/>
          <p:cNvSpPr/>
          <p:nvPr/>
        </p:nvSpPr>
        <p:spPr>
          <a:xfrm flipH="1">
            <a:off x="477720" y="5862600"/>
            <a:ext cx="4096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Line 828"/>
          <p:cNvSpPr/>
          <p:nvPr/>
        </p:nvSpPr>
        <p:spPr>
          <a:xfrm flipH="1">
            <a:off x="477720" y="5983200"/>
            <a:ext cx="4096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Line 829"/>
          <p:cNvSpPr/>
          <p:nvPr/>
        </p:nvSpPr>
        <p:spPr>
          <a:xfrm flipH="1">
            <a:off x="477720" y="6103800"/>
            <a:ext cx="4096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Line 830"/>
          <p:cNvSpPr/>
          <p:nvPr/>
        </p:nvSpPr>
        <p:spPr>
          <a:xfrm flipH="1">
            <a:off x="477720" y="6213600"/>
            <a:ext cx="4096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Line 831"/>
          <p:cNvSpPr/>
          <p:nvPr/>
        </p:nvSpPr>
        <p:spPr>
          <a:xfrm flipH="1">
            <a:off x="477720" y="6332400"/>
            <a:ext cx="4096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Line 832"/>
          <p:cNvSpPr/>
          <p:nvPr/>
        </p:nvSpPr>
        <p:spPr>
          <a:xfrm flipH="1">
            <a:off x="477720" y="6453360"/>
            <a:ext cx="4096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Line 833"/>
          <p:cNvSpPr/>
          <p:nvPr/>
        </p:nvSpPr>
        <p:spPr>
          <a:xfrm flipH="1">
            <a:off x="477720" y="6562800"/>
            <a:ext cx="4096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Line 834"/>
          <p:cNvSpPr/>
          <p:nvPr/>
        </p:nvSpPr>
        <p:spPr>
          <a:xfrm flipH="1">
            <a:off x="477720" y="7153200"/>
            <a:ext cx="4096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Line 835"/>
          <p:cNvSpPr/>
          <p:nvPr/>
        </p:nvSpPr>
        <p:spPr>
          <a:xfrm flipH="1">
            <a:off x="477720" y="1116000"/>
            <a:ext cx="12016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Line 836"/>
          <p:cNvSpPr/>
          <p:nvPr/>
        </p:nvSpPr>
        <p:spPr>
          <a:xfrm flipH="1">
            <a:off x="1707840" y="1258920"/>
            <a:ext cx="10508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Line 837"/>
          <p:cNvSpPr/>
          <p:nvPr/>
        </p:nvSpPr>
        <p:spPr>
          <a:xfrm flipH="1">
            <a:off x="1708200" y="1376280"/>
            <a:ext cx="12780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Line 838"/>
          <p:cNvSpPr/>
          <p:nvPr/>
        </p:nvSpPr>
        <p:spPr>
          <a:xfrm flipH="1">
            <a:off x="3119040" y="1547640"/>
            <a:ext cx="5540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Line 839"/>
          <p:cNvSpPr/>
          <p:nvPr/>
        </p:nvSpPr>
        <p:spPr>
          <a:xfrm flipH="1">
            <a:off x="3119040" y="2076480"/>
            <a:ext cx="5936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Line 840"/>
          <p:cNvSpPr/>
          <p:nvPr/>
        </p:nvSpPr>
        <p:spPr>
          <a:xfrm>
            <a:off x="3706920" y="2195640"/>
            <a:ext cx="360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Line 841"/>
          <p:cNvSpPr/>
          <p:nvPr/>
        </p:nvSpPr>
        <p:spPr>
          <a:xfrm>
            <a:off x="3706920" y="2316240"/>
            <a:ext cx="360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Line 842"/>
          <p:cNvSpPr/>
          <p:nvPr/>
        </p:nvSpPr>
        <p:spPr>
          <a:xfrm>
            <a:off x="3708360" y="1908000"/>
            <a:ext cx="0" cy="400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Line 843"/>
          <p:cNvSpPr/>
          <p:nvPr/>
        </p:nvSpPr>
        <p:spPr>
          <a:xfrm>
            <a:off x="3119400" y="1547640"/>
            <a:ext cx="0" cy="12668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Line 844"/>
          <p:cNvSpPr/>
          <p:nvPr/>
        </p:nvSpPr>
        <p:spPr>
          <a:xfrm>
            <a:off x="3817800" y="2427120"/>
            <a:ext cx="0" cy="1101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Line 845"/>
          <p:cNvSpPr/>
          <p:nvPr/>
        </p:nvSpPr>
        <p:spPr>
          <a:xfrm>
            <a:off x="3817800" y="3529080"/>
            <a:ext cx="360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Line 846"/>
          <p:cNvSpPr/>
          <p:nvPr/>
        </p:nvSpPr>
        <p:spPr>
          <a:xfrm>
            <a:off x="3817800" y="3402000"/>
            <a:ext cx="324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Line 847"/>
          <p:cNvSpPr/>
          <p:nvPr/>
        </p:nvSpPr>
        <p:spPr>
          <a:xfrm>
            <a:off x="3817800" y="3276720"/>
            <a:ext cx="360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Line 848"/>
          <p:cNvSpPr/>
          <p:nvPr/>
        </p:nvSpPr>
        <p:spPr>
          <a:xfrm>
            <a:off x="3817800" y="3164040"/>
            <a:ext cx="454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Line 849"/>
          <p:cNvSpPr/>
          <p:nvPr/>
        </p:nvSpPr>
        <p:spPr>
          <a:xfrm>
            <a:off x="3817800" y="3057480"/>
            <a:ext cx="3128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Line 850"/>
          <p:cNvSpPr/>
          <p:nvPr/>
        </p:nvSpPr>
        <p:spPr>
          <a:xfrm>
            <a:off x="3817800" y="2916360"/>
            <a:ext cx="360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Line 851"/>
          <p:cNvSpPr/>
          <p:nvPr/>
        </p:nvSpPr>
        <p:spPr>
          <a:xfrm>
            <a:off x="1708200" y="2306520"/>
            <a:ext cx="1411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Line 852"/>
          <p:cNvSpPr/>
          <p:nvPr/>
        </p:nvSpPr>
        <p:spPr>
          <a:xfrm flipH="1">
            <a:off x="1708200" y="3538440"/>
            <a:ext cx="3492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Line 853"/>
          <p:cNvSpPr/>
          <p:nvPr/>
        </p:nvSpPr>
        <p:spPr>
          <a:xfrm flipH="1">
            <a:off x="1707840" y="3664080"/>
            <a:ext cx="587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Line 854"/>
          <p:cNvSpPr/>
          <p:nvPr/>
        </p:nvSpPr>
        <p:spPr>
          <a:xfrm flipH="1">
            <a:off x="1707840" y="3795840"/>
            <a:ext cx="587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Line 855"/>
          <p:cNvSpPr/>
          <p:nvPr/>
        </p:nvSpPr>
        <p:spPr>
          <a:xfrm flipH="1">
            <a:off x="1707840" y="3917880"/>
            <a:ext cx="587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Line 856"/>
          <p:cNvSpPr/>
          <p:nvPr/>
        </p:nvSpPr>
        <p:spPr>
          <a:xfrm flipH="1">
            <a:off x="1707840" y="4035600"/>
            <a:ext cx="587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Line 857"/>
          <p:cNvSpPr/>
          <p:nvPr/>
        </p:nvSpPr>
        <p:spPr>
          <a:xfrm>
            <a:off x="1709640" y="1258920"/>
            <a:ext cx="0" cy="2763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Line 858"/>
          <p:cNvSpPr/>
          <p:nvPr/>
        </p:nvSpPr>
        <p:spPr>
          <a:xfrm>
            <a:off x="477720" y="1908000"/>
            <a:ext cx="122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Line 859"/>
          <p:cNvSpPr/>
          <p:nvPr/>
        </p:nvSpPr>
        <p:spPr>
          <a:xfrm>
            <a:off x="477720" y="4462560"/>
            <a:ext cx="97164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Line 860"/>
          <p:cNvSpPr/>
          <p:nvPr/>
        </p:nvSpPr>
        <p:spPr>
          <a:xfrm>
            <a:off x="477720" y="5283360"/>
            <a:ext cx="935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Line 861"/>
          <p:cNvSpPr/>
          <p:nvPr/>
        </p:nvSpPr>
        <p:spPr>
          <a:xfrm>
            <a:off x="477720" y="5745240"/>
            <a:ext cx="19828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Line 862"/>
          <p:cNvSpPr/>
          <p:nvPr/>
        </p:nvSpPr>
        <p:spPr>
          <a:xfrm>
            <a:off x="477720" y="5864400"/>
            <a:ext cx="20844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Line 863"/>
          <p:cNvSpPr/>
          <p:nvPr/>
        </p:nvSpPr>
        <p:spPr>
          <a:xfrm>
            <a:off x="477720" y="5985000"/>
            <a:ext cx="20624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Line 864"/>
          <p:cNvSpPr/>
          <p:nvPr/>
        </p:nvSpPr>
        <p:spPr>
          <a:xfrm>
            <a:off x="477720" y="6105600"/>
            <a:ext cx="20624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Line 865"/>
          <p:cNvSpPr/>
          <p:nvPr/>
        </p:nvSpPr>
        <p:spPr>
          <a:xfrm>
            <a:off x="477720" y="6215040"/>
            <a:ext cx="20624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Line 866"/>
          <p:cNvSpPr/>
          <p:nvPr/>
        </p:nvSpPr>
        <p:spPr>
          <a:xfrm>
            <a:off x="477720" y="6334200"/>
            <a:ext cx="2167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Line 867"/>
          <p:cNvSpPr/>
          <p:nvPr/>
        </p:nvSpPr>
        <p:spPr>
          <a:xfrm>
            <a:off x="477720" y="6454800"/>
            <a:ext cx="20624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Line 868"/>
          <p:cNvSpPr/>
          <p:nvPr/>
        </p:nvSpPr>
        <p:spPr>
          <a:xfrm>
            <a:off x="477720" y="6564240"/>
            <a:ext cx="20844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Line 869"/>
          <p:cNvSpPr/>
          <p:nvPr/>
        </p:nvSpPr>
        <p:spPr>
          <a:xfrm>
            <a:off x="477720" y="7153200"/>
            <a:ext cx="17416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Line 870"/>
          <p:cNvSpPr/>
          <p:nvPr/>
        </p:nvSpPr>
        <p:spPr>
          <a:xfrm>
            <a:off x="2227320" y="6683400"/>
            <a:ext cx="0" cy="11667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Line 871"/>
          <p:cNvSpPr/>
          <p:nvPr/>
        </p:nvSpPr>
        <p:spPr>
          <a:xfrm>
            <a:off x="2227320" y="6915240"/>
            <a:ext cx="32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Line 872"/>
          <p:cNvSpPr/>
          <p:nvPr/>
        </p:nvSpPr>
        <p:spPr>
          <a:xfrm>
            <a:off x="2227320" y="7034040"/>
            <a:ext cx="32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Line 873"/>
          <p:cNvSpPr/>
          <p:nvPr/>
        </p:nvSpPr>
        <p:spPr>
          <a:xfrm>
            <a:off x="2227320" y="7275600"/>
            <a:ext cx="32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Line 874"/>
          <p:cNvSpPr/>
          <p:nvPr/>
        </p:nvSpPr>
        <p:spPr>
          <a:xfrm>
            <a:off x="2227320" y="7380360"/>
            <a:ext cx="32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Line 875"/>
          <p:cNvSpPr/>
          <p:nvPr/>
        </p:nvSpPr>
        <p:spPr>
          <a:xfrm>
            <a:off x="2227320" y="7504200"/>
            <a:ext cx="32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Line 876"/>
          <p:cNvSpPr/>
          <p:nvPr/>
        </p:nvSpPr>
        <p:spPr>
          <a:xfrm>
            <a:off x="2227320" y="7624800"/>
            <a:ext cx="32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Line 877"/>
          <p:cNvSpPr/>
          <p:nvPr/>
        </p:nvSpPr>
        <p:spPr>
          <a:xfrm>
            <a:off x="2227320" y="7734240"/>
            <a:ext cx="32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Line 878"/>
          <p:cNvSpPr/>
          <p:nvPr/>
        </p:nvSpPr>
        <p:spPr>
          <a:xfrm>
            <a:off x="2227320" y="7854840"/>
            <a:ext cx="32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Line 879"/>
          <p:cNvSpPr/>
          <p:nvPr/>
        </p:nvSpPr>
        <p:spPr>
          <a:xfrm>
            <a:off x="477720" y="8232840"/>
            <a:ext cx="1479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AutoShape 880"/>
          <p:cNvSpPr/>
          <p:nvPr/>
        </p:nvSpPr>
        <p:spPr>
          <a:xfrm>
            <a:off x="4056120" y="324000"/>
            <a:ext cx="71280" cy="576000"/>
          </a:xfrm>
          <a:custGeom>
            <a:avLst/>
            <a:gdLst>
              <a:gd name="textAreaLeft" fmla="*/ 0 w 71280"/>
              <a:gd name="textAreaRight" fmla="*/ 25560 w 71280"/>
              <a:gd name="textAreaTop" fmla="*/ 14760 h 576000"/>
              <a:gd name="textAreaBottom" fmla="*/ 561240 h 576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Text Box 881"/>
          <p:cNvSpPr/>
          <p:nvPr/>
        </p:nvSpPr>
        <p:spPr>
          <a:xfrm>
            <a:off x="4204080" y="468360"/>
            <a:ext cx="67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MvSsp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Line 882"/>
          <p:cNvSpPr/>
          <p:nvPr/>
        </p:nvSpPr>
        <p:spPr>
          <a:xfrm>
            <a:off x="2227320" y="7155000"/>
            <a:ext cx="647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AutoShape 883"/>
          <p:cNvSpPr/>
          <p:nvPr/>
        </p:nvSpPr>
        <p:spPr>
          <a:xfrm>
            <a:off x="2852640" y="4211640"/>
            <a:ext cx="71640" cy="144360"/>
          </a:xfrm>
          <a:custGeom>
            <a:avLst/>
            <a:gdLst>
              <a:gd name="textAreaLeft" fmla="*/ 0 w 71640"/>
              <a:gd name="textAreaRight" fmla="*/ 25920 w 71640"/>
              <a:gd name="textAreaTop" fmla="*/ 3600 h 144360"/>
              <a:gd name="textAreaBottom" fmla="*/ 140760 h 1443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Text Box 884"/>
          <p:cNvSpPr/>
          <p:nvPr/>
        </p:nvSpPr>
        <p:spPr>
          <a:xfrm>
            <a:off x="2999520" y="4140360"/>
            <a:ext cx="511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MvLfj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AutoShape 885"/>
          <p:cNvSpPr/>
          <p:nvPr/>
        </p:nvSpPr>
        <p:spPr>
          <a:xfrm>
            <a:off x="4724280" y="1403280"/>
            <a:ext cx="73080" cy="217440"/>
          </a:xfrm>
          <a:custGeom>
            <a:avLst/>
            <a:gdLst>
              <a:gd name="textAreaLeft" fmla="*/ 0 w 73080"/>
              <a:gd name="textAreaRight" fmla="*/ 26280 w 73080"/>
              <a:gd name="textAreaTop" fmla="*/ 5400 h 217440"/>
              <a:gd name="textAreaBottom" fmla="*/ 212040 h 2174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Text Box 886"/>
          <p:cNvSpPr/>
          <p:nvPr/>
        </p:nvSpPr>
        <p:spPr>
          <a:xfrm>
            <a:off x="4797360" y="1403280"/>
            <a:ext cx="719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MvLf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AutoShape 887"/>
          <p:cNvSpPr/>
          <p:nvPr/>
        </p:nvSpPr>
        <p:spPr>
          <a:xfrm>
            <a:off x="2852640" y="4500720"/>
            <a:ext cx="71640" cy="287280"/>
          </a:xfrm>
          <a:custGeom>
            <a:avLst/>
            <a:gdLst>
              <a:gd name="textAreaLeft" fmla="*/ 0 w 71640"/>
              <a:gd name="textAreaRight" fmla="*/ 25920 w 71640"/>
              <a:gd name="textAreaTop" fmla="*/ 7200 h 287280"/>
              <a:gd name="textAreaBottom" fmla="*/ 280080 h 2872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Text Box 888"/>
          <p:cNvSpPr/>
          <p:nvPr/>
        </p:nvSpPr>
        <p:spPr>
          <a:xfrm>
            <a:off x="2999160" y="4500720"/>
            <a:ext cx="579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MvSv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AutoShape 889"/>
          <p:cNvSpPr/>
          <p:nvPr/>
        </p:nvSpPr>
        <p:spPr>
          <a:xfrm>
            <a:off x="5445000" y="1692360"/>
            <a:ext cx="71640" cy="431640"/>
          </a:xfrm>
          <a:custGeom>
            <a:avLst/>
            <a:gdLst>
              <a:gd name="textAreaLeft" fmla="*/ 0 w 71640"/>
              <a:gd name="textAreaRight" fmla="*/ 25920 w 71640"/>
              <a:gd name="textAreaTop" fmla="*/ 11160 h 431640"/>
              <a:gd name="textAreaBottom" fmla="*/ 420480 h 4316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Text Box 890"/>
          <p:cNvSpPr/>
          <p:nvPr/>
        </p:nvSpPr>
        <p:spPr>
          <a:xfrm>
            <a:off x="5518800" y="1763640"/>
            <a:ext cx="517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MvS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AutoShape 891"/>
          <p:cNvSpPr/>
          <p:nvPr/>
        </p:nvSpPr>
        <p:spPr>
          <a:xfrm>
            <a:off x="2924280" y="4932360"/>
            <a:ext cx="73080" cy="719280"/>
          </a:xfrm>
          <a:custGeom>
            <a:avLst/>
            <a:gdLst>
              <a:gd name="textAreaLeft" fmla="*/ 0 w 73080"/>
              <a:gd name="textAreaRight" fmla="*/ 26280 w 73080"/>
              <a:gd name="textAreaTop" fmla="*/ 18720 h 719280"/>
              <a:gd name="textAreaBottom" fmla="*/ 700560 h 7192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Text Box 892"/>
          <p:cNvSpPr/>
          <p:nvPr/>
        </p:nvSpPr>
        <p:spPr>
          <a:xfrm>
            <a:off x="3071160" y="5148360"/>
            <a:ext cx="60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MvSof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AutoShape 893"/>
          <p:cNvSpPr/>
          <p:nvPr/>
        </p:nvSpPr>
        <p:spPr>
          <a:xfrm>
            <a:off x="3933720" y="7885080"/>
            <a:ext cx="71640" cy="934920"/>
          </a:xfrm>
          <a:custGeom>
            <a:avLst/>
            <a:gdLst>
              <a:gd name="textAreaLeft" fmla="*/ 0 w 71640"/>
              <a:gd name="textAreaRight" fmla="*/ 25920 w 71640"/>
              <a:gd name="textAreaTop" fmla="*/ 24120 h 934920"/>
              <a:gd name="textAreaBottom" fmla="*/ 910800 h 934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Text Box 894"/>
          <p:cNvSpPr/>
          <p:nvPr/>
        </p:nvSpPr>
        <p:spPr>
          <a:xfrm>
            <a:off x="4080600" y="8244000"/>
            <a:ext cx="517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MvD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AutoShape 813"/>
          <p:cNvSpPr/>
          <p:nvPr/>
        </p:nvSpPr>
        <p:spPr>
          <a:xfrm>
            <a:off x="5154480" y="2421000"/>
            <a:ext cx="73080" cy="431640"/>
          </a:xfrm>
          <a:custGeom>
            <a:avLst/>
            <a:gdLst>
              <a:gd name="textAreaLeft" fmla="*/ 0 w 73080"/>
              <a:gd name="textAreaRight" fmla="*/ 26280 w 73080"/>
              <a:gd name="textAreaTop" fmla="*/ 11160 h 431640"/>
              <a:gd name="textAreaBottom" fmla="*/ 420480 h 4316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Text Box 814"/>
          <p:cNvSpPr/>
          <p:nvPr/>
        </p:nvSpPr>
        <p:spPr>
          <a:xfrm>
            <a:off x="5374440" y="2492280"/>
            <a:ext cx="517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7f7f7f"/>
                </a:solidFill>
                <a:latin typeface="Arial"/>
              </a:rPr>
              <a:t>MvS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AutoShape 818"/>
          <p:cNvSpPr/>
          <p:nvPr/>
        </p:nvSpPr>
        <p:spPr>
          <a:xfrm>
            <a:off x="5143680" y="2925720"/>
            <a:ext cx="71280" cy="574560"/>
          </a:xfrm>
          <a:custGeom>
            <a:avLst/>
            <a:gdLst>
              <a:gd name="textAreaLeft" fmla="*/ 0 w 71280"/>
              <a:gd name="textAreaRight" fmla="*/ 25560 w 71280"/>
              <a:gd name="textAreaTop" fmla="*/ 12600 h 574560"/>
              <a:gd name="textAreaBottom" fmla="*/ 561960 h 5745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771"/>
                  <a:pt x="10800" y="1542"/>
                </a:cubicBezTo>
                <a:lnTo>
                  <a:pt x="10800" y="9258"/>
                </a:lnTo>
                <a:cubicBezTo>
                  <a:pt x="10800" y="10029"/>
                  <a:pt x="16200" y="10800"/>
                  <a:pt x="21600" y="10800"/>
                </a:cubicBezTo>
                <a:cubicBezTo>
                  <a:pt x="16200" y="10800"/>
                  <a:pt x="10800" y="11571"/>
                  <a:pt x="10800" y="12342"/>
                </a:cubicBezTo>
                <a:lnTo>
                  <a:pt x="10800" y="20058"/>
                </a:lnTo>
                <a:cubicBezTo>
                  <a:pt x="10800" y="20829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Text Box 819"/>
          <p:cNvSpPr/>
          <p:nvPr/>
        </p:nvSpPr>
        <p:spPr>
          <a:xfrm>
            <a:off x="5231520" y="299736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7f7f7f"/>
                </a:solidFill>
                <a:latin typeface="Arial"/>
              </a:rPr>
              <a:t>MvS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AutoShape 822"/>
          <p:cNvSpPr/>
          <p:nvPr/>
        </p:nvSpPr>
        <p:spPr>
          <a:xfrm>
            <a:off x="4286160" y="1111320"/>
            <a:ext cx="85680" cy="142920"/>
          </a:xfrm>
          <a:custGeom>
            <a:avLst/>
            <a:gdLst>
              <a:gd name="textAreaLeft" fmla="*/ 0 w 85680"/>
              <a:gd name="textAreaRight" fmla="*/ 30960 w 85680"/>
              <a:gd name="textAreaTop" fmla="*/ 9000 h 142920"/>
              <a:gd name="textAreaBottom" fmla="*/ 13392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2184"/>
                  <a:pt x="10800" y="4368"/>
                </a:cubicBezTo>
                <a:lnTo>
                  <a:pt x="10800" y="6432"/>
                </a:lnTo>
                <a:cubicBezTo>
                  <a:pt x="10800" y="8616"/>
                  <a:pt x="16200" y="10800"/>
                  <a:pt x="21600" y="10800"/>
                </a:cubicBezTo>
                <a:cubicBezTo>
                  <a:pt x="16200" y="10800"/>
                  <a:pt x="10800" y="12984"/>
                  <a:pt x="10800" y="15168"/>
                </a:cubicBezTo>
                <a:lnTo>
                  <a:pt x="10800" y="17232"/>
                </a:lnTo>
                <a:cubicBezTo>
                  <a:pt x="10800" y="19416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Text Box 823"/>
          <p:cNvSpPr/>
          <p:nvPr/>
        </p:nvSpPr>
        <p:spPr>
          <a:xfrm>
            <a:off x="4357800" y="1039680"/>
            <a:ext cx="677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7f7f7f"/>
                </a:solidFill>
                <a:latin typeface="Arial"/>
              </a:rPr>
              <a:t>MvSle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AutoShape 822"/>
          <p:cNvSpPr/>
          <p:nvPr/>
        </p:nvSpPr>
        <p:spPr>
          <a:xfrm>
            <a:off x="4071960" y="968400"/>
            <a:ext cx="85680" cy="142920"/>
          </a:xfrm>
          <a:custGeom>
            <a:avLst/>
            <a:gdLst>
              <a:gd name="textAreaLeft" fmla="*/ 0 w 85680"/>
              <a:gd name="textAreaRight" fmla="*/ 30960 w 85680"/>
              <a:gd name="textAreaTop" fmla="*/ 9000 h 142920"/>
              <a:gd name="textAreaBottom" fmla="*/ 13392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2184"/>
                  <a:pt x="10800" y="4368"/>
                </a:cubicBezTo>
                <a:lnTo>
                  <a:pt x="10800" y="6432"/>
                </a:lnTo>
                <a:cubicBezTo>
                  <a:pt x="10800" y="8616"/>
                  <a:pt x="16200" y="10800"/>
                  <a:pt x="21600" y="10800"/>
                </a:cubicBezTo>
                <a:cubicBezTo>
                  <a:pt x="16200" y="10800"/>
                  <a:pt x="10800" y="12984"/>
                  <a:pt x="10800" y="15168"/>
                </a:cubicBezTo>
                <a:lnTo>
                  <a:pt x="10800" y="17232"/>
                </a:lnTo>
                <a:cubicBezTo>
                  <a:pt x="10800" y="19416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Text Box 823"/>
          <p:cNvSpPr/>
          <p:nvPr/>
        </p:nvSpPr>
        <p:spPr>
          <a:xfrm>
            <a:off x="4143240" y="896760"/>
            <a:ext cx="677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7f7f7f"/>
                </a:solidFill>
                <a:latin typeface="Arial"/>
              </a:rPr>
              <a:t>MvSte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Text Box 823"/>
          <p:cNvSpPr/>
          <p:nvPr/>
        </p:nvSpPr>
        <p:spPr>
          <a:xfrm>
            <a:off x="4401360" y="1214280"/>
            <a:ext cx="560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7f7f7f"/>
                </a:solidFill>
                <a:latin typeface="Arial"/>
              </a:rPr>
              <a:t>MvSo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AutoShape 822"/>
          <p:cNvSpPr/>
          <p:nvPr/>
        </p:nvSpPr>
        <p:spPr>
          <a:xfrm>
            <a:off x="4214880" y="1263600"/>
            <a:ext cx="85680" cy="142920"/>
          </a:xfrm>
          <a:custGeom>
            <a:avLst/>
            <a:gdLst>
              <a:gd name="textAreaLeft" fmla="*/ 0 w 85680"/>
              <a:gd name="textAreaRight" fmla="*/ 30960 w 85680"/>
              <a:gd name="textAreaTop" fmla="*/ 9000 h 142920"/>
              <a:gd name="textAreaBottom" fmla="*/ 13392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2184"/>
                  <a:pt x="10800" y="4368"/>
                </a:cubicBezTo>
                <a:lnTo>
                  <a:pt x="10800" y="6432"/>
                </a:lnTo>
                <a:cubicBezTo>
                  <a:pt x="10800" y="8616"/>
                  <a:pt x="16200" y="10800"/>
                  <a:pt x="21600" y="10800"/>
                </a:cubicBezTo>
                <a:cubicBezTo>
                  <a:pt x="16200" y="10800"/>
                  <a:pt x="10800" y="12984"/>
                  <a:pt x="10800" y="15168"/>
                </a:cubicBezTo>
                <a:lnTo>
                  <a:pt x="10800" y="17232"/>
                </a:lnTo>
                <a:cubicBezTo>
                  <a:pt x="10800" y="19416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AutoShape 810"/>
          <p:cNvSpPr/>
          <p:nvPr/>
        </p:nvSpPr>
        <p:spPr>
          <a:xfrm>
            <a:off x="3143160" y="3357720"/>
            <a:ext cx="71640" cy="645840"/>
          </a:xfrm>
          <a:custGeom>
            <a:avLst/>
            <a:gdLst>
              <a:gd name="textAreaLeft" fmla="*/ 0 w 71640"/>
              <a:gd name="textAreaRight" fmla="*/ 25920 w 71640"/>
              <a:gd name="textAreaTop" fmla="*/ 12960 h 645840"/>
              <a:gd name="textAreaBottom" fmla="*/ 632880 h 6458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701"/>
                  <a:pt x="10800" y="1402"/>
                </a:cubicBezTo>
                <a:lnTo>
                  <a:pt x="10800" y="9398"/>
                </a:lnTo>
                <a:cubicBezTo>
                  <a:pt x="10800" y="10099"/>
                  <a:pt x="16200" y="10800"/>
                  <a:pt x="21600" y="10800"/>
                </a:cubicBezTo>
                <a:cubicBezTo>
                  <a:pt x="16200" y="10800"/>
                  <a:pt x="10800" y="11501"/>
                  <a:pt x="10800" y="12202"/>
                </a:cubicBezTo>
                <a:lnTo>
                  <a:pt x="10800" y="20198"/>
                </a:lnTo>
                <a:cubicBezTo>
                  <a:pt x="10800" y="20899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Text Box 811"/>
          <p:cNvSpPr/>
          <p:nvPr/>
        </p:nvSpPr>
        <p:spPr>
          <a:xfrm>
            <a:off x="3290040" y="364320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7f7f7f"/>
                </a:solidFill>
                <a:latin typeface="Arial"/>
              </a:rPr>
              <a:t>MvS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Text Box 514"/>
          <p:cNvSpPr/>
          <p:nvPr/>
        </p:nvSpPr>
        <p:spPr>
          <a:xfrm>
            <a:off x="4145040" y="7148520"/>
            <a:ext cx="71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7f7f7f"/>
                </a:solidFill>
                <a:latin typeface="Arial"/>
              </a:rPr>
              <a:t>MvDsp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AutoShape 515"/>
          <p:cNvSpPr/>
          <p:nvPr/>
        </p:nvSpPr>
        <p:spPr>
          <a:xfrm>
            <a:off x="4071960" y="6572160"/>
            <a:ext cx="73080" cy="1297080"/>
          </a:xfrm>
          <a:custGeom>
            <a:avLst/>
            <a:gdLst>
              <a:gd name="textAreaLeft" fmla="*/ 0 w 73080"/>
              <a:gd name="textAreaRight" fmla="*/ 26280 w 73080"/>
              <a:gd name="textAreaTop" fmla="*/ 33480 h 1297080"/>
              <a:gd name="textAreaBottom" fmla="*/ 1263600 h 12970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476"/>
                </a:lnTo>
                <a:cubicBezTo>
                  <a:pt x="10800" y="10376"/>
                  <a:pt x="16200" y="11276"/>
                  <a:pt x="21600" y="11276"/>
                </a:cubicBezTo>
                <a:cubicBezTo>
                  <a:pt x="16200" y="11276"/>
                  <a:pt x="10800" y="12176"/>
                  <a:pt x="10800" y="13076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Text Box 512"/>
          <p:cNvSpPr/>
          <p:nvPr/>
        </p:nvSpPr>
        <p:spPr>
          <a:xfrm>
            <a:off x="4073400" y="6060960"/>
            <a:ext cx="719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7f7f7f"/>
                </a:solidFill>
                <a:latin typeface="Arial"/>
              </a:rPr>
              <a:t>MvDsp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AutoShape 513"/>
          <p:cNvSpPr/>
          <p:nvPr/>
        </p:nvSpPr>
        <p:spPr>
          <a:xfrm>
            <a:off x="4000680" y="5715000"/>
            <a:ext cx="72720" cy="857160"/>
          </a:xfrm>
          <a:custGeom>
            <a:avLst/>
            <a:gdLst>
              <a:gd name="textAreaLeft" fmla="*/ 0 w 72720"/>
              <a:gd name="textAreaRight" fmla="*/ 26280 w 72720"/>
              <a:gd name="textAreaTop" fmla="*/ 16560 h 857160"/>
              <a:gd name="textAreaBottom" fmla="*/ 840600 h 8571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680"/>
                  <a:pt x="10800" y="1360"/>
                </a:cubicBezTo>
                <a:lnTo>
                  <a:pt x="10800" y="9916"/>
                </a:lnTo>
                <a:cubicBezTo>
                  <a:pt x="10800" y="10596"/>
                  <a:pt x="16200" y="11276"/>
                  <a:pt x="21600" y="11276"/>
                </a:cubicBezTo>
                <a:cubicBezTo>
                  <a:pt x="16200" y="11276"/>
                  <a:pt x="10800" y="11956"/>
                  <a:pt x="10800" y="12636"/>
                </a:cubicBezTo>
                <a:lnTo>
                  <a:pt x="10800" y="20240"/>
                </a:lnTo>
                <a:cubicBezTo>
                  <a:pt x="10800" y="20920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AutoShape 813"/>
          <p:cNvSpPr/>
          <p:nvPr/>
        </p:nvSpPr>
        <p:spPr>
          <a:xfrm>
            <a:off x="5072040" y="2143080"/>
            <a:ext cx="73080" cy="214200"/>
          </a:xfrm>
          <a:custGeom>
            <a:avLst/>
            <a:gdLst>
              <a:gd name="textAreaLeft" fmla="*/ 0 w 73080"/>
              <a:gd name="textAreaRight" fmla="*/ 26280 w 73080"/>
              <a:gd name="textAreaTop" fmla="*/ 11160 h 214200"/>
              <a:gd name="textAreaBottom" fmla="*/ 203040 h 2142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814"/>
                  <a:pt x="10800" y="3627"/>
                </a:cubicBezTo>
                <a:lnTo>
                  <a:pt x="10800" y="7173"/>
                </a:lnTo>
                <a:cubicBezTo>
                  <a:pt x="10800" y="8987"/>
                  <a:pt x="16200" y="10800"/>
                  <a:pt x="21600" y="10800"/>
                </a:cubicBezTo>
                <a:cubicBezTo>
                  <a:pt x="16200" y="10800"/>
                  <a:pt x="10800" y="12614"/>
                  <a:pt x="10800" y="14427"/>
                </a:cubicBezTo>
                <a:lnTo>
                  <a:pt x="10800" y="17973"/>
                </a:lnTo>
                <a:cubicBezTo>
                  <a:pt x="10800" y="19787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Text Box 814"/>
          <p:cNvSpPr/>
          <p:nvPr/>
        </p:nvSpPr>
        <p:spPr>
          <a:xfrm>
            <a:off x="5214960" y="2143080"/>
            <a:ext cx="855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7f7f7f"/>
                </a:solidFill>
                <a:latin typeface="Arial"/>
              </a:rPr>
              <a:t>MvSv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1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7-22T09:48:36Z</dcterms:created>
  <dc:creator>Tatiana</dc:creator>
  <dc:description/>
  <dc:language>en-US</dc:language>
  <cp:lastModifiedBy> </cp:lastModifiedBy>
  <dcterms:modified xsi:type="dcterms:W3CDTF">2008-03-15T10:57:24Z</dcterms:modified>
  <cp:revision>49</cp:revision>
  <dc:subject/>
  <dc:title>Diapositive 1</dc:title>
</cp:coreProperties>
</file>